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12192000" cy="162179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5" y="-10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Rnq-W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Rnq-W.xl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W2%20W3.xls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areaChart>
        <c:grouping val="standar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cat>
            <c:numRef>
              <c:f>Лист3!$D$2:$D$223</c:f>
              <c:numCache>
                <c:formatCode>General</c:formatCode>
                <c:ptCount val="2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</c:numCache>
            </c:numRef>
          </c:cat>
          <c:val>
            <c:numRef>
              <c:f>Лист3!$C$2:$C$223</c:f>
              <c:numCache>
                <c:formatCode>General</c:formatCode>
                <c:ptCount val="222"/>
                <c:pt idx="0">
                  <c:v>0.99999987466902462</c:v>
                </c:pt>
                <c:pt idx="1">
                  <c:v>0.99999987466902462</c:v>
                </c:pt>
                <c:pt idx="2">
                  <c:v>0.99999987466902462</c:v>
                </c:pt>
                <c:pt idx="3">
                  <c:v>0.99999987466902462</c:v>
                </c:pt>
                <c:pt idx="4">
                  <c:v>0.99999987466902462</c:v>
                </c:pt>
                <c:pt idx="5">
                  <c:v>0.99999987466902462</c:v>
                </c:pt>
                <c:pt idx="6">
                  <c:v>0.99999987466902462</c:v>
                </c:pt>
                <c:pt idx="7">
                  <c:v>0.99999987466902462</c:v>
                </c:pt>
                <c:pt idx="8">
                  <c:v>0.99999987466902462</c:v>
                </c:pt>
                <c:pt idx="9">
                  <c:v>0.99999987466902462</c:v>
                </c:pt>
                <c:pt idx="10">
                  <c:v>0.99999987466902462</c:v>
                </c:pt>
                <c:pt idx="11">
                  <c:v>0.99999987466902462</c:v>
                </c:pt>
                <c:pt idx="12">
                  <c:v>0.99999987466902462</c:v>
                </c:pt>
                <c:pt idx="13">
                  <c:v>0.99999987466902462</c:v>
                </c:pt>
                <c:pt idx="14">
                  <c:v>0.99999987466902462</c:v>
                </c:pt>
                <c:pt idx="15">
                  <c:v>0.99999987466902462</c:v>
                </c:pt>
                <c:pt idx="16">
                  <c:v>0.99999987466902462</c:v>
                </c:pt>
                <c:pt idx="17">
                  <c:v>0.99999987466902462</c:v>
                </c:pt>
                <c:pt idx="18">
                  <c:v>0.99999987466902462</c:v>
                </c:pt>
                <c:pt idx="19">
                  <c:v>0.99999987466902462</c:v>
                </c:pt>
                <c:pt idx="20">
                  <c:v>0.99999987466902462</c:v>
                </c:pt>
                <c:pt idx="21">
                  <c:v>0.99999987466902462</c:v>
                </c:pt>
                <c:pt idx="22">
                  <c:v>0.99999987466902462</c:v>
                </c:pt>
                <c:pt idx="23">
                  <c:v>0.99999987466902462</c:v>
                </c:pt>
                <c:pt idx="24">
                  <c:v>0.99999987466902462</c:v>
                </c:pt>
                <c:pt idx="25">
                  <c:v>0.99999987466902462</c:v>
                </c:pt>
                <c:pt idx="26">
                  <c:v>0.99999987466902462</c:v>
                </c:pt>
                <c:pt idx="27">
                  <c:v>0.99999987466902462</c:v>
                </c:pt>
                <c:pt idx="28">
                  <c:v>0.99999987466902462</c:v>
                </c:pt>
                <c:pt idx="29">
                  <c:v>0.99999987466902462</c:v>
                </c:pt>
                <c:pt idx="30">
                  <c:v>0.99507357887092107</c:v>
                </c:pt>
                <c:pt idx="31">
                  <c:v>0.98323144544796592</c:v>
                </c:pt>
                <c:pt idx="32">
                  <c:v>0.98323144544796592</c:v>
                </c:pt>
                <c:pt idx="33">
                  <c:v>0.98323144544796592</c:v>
                </c:pt>
                <c:pt idx="34">
                  <c:v>0.97045002634186461</c:v>
                </c:pt>
                <c:pt idx="35">
                  <c:v>0.97045002634186461</c:v>
                </c:pt>
                <c:pt idx="36">
                  <c:v>0.96535727485307699</c:v>
                </c:pt>
                <c:pt idx="37">
                  <c:v>0.93490777315007678</c:v>
                </c:pt>
                <c:pt idx="38">
                  <c:v>0.93490777315007678</c:v>
                </c:pt>
                <c:pt idx="39">
                  <c:v>0.93490777315007678</c:v>
                </c:pt>
                <c:pt idx="40">
                  <c:v>0.93490777315007678</c:v>
                </c:pt>
                <c:pt idx="41">
                  <c:v>0.17612347039729606</c:v>
                </c:pt>
                <c:pt idx="42">
                  <c:v>0.17612347039729606</c:v>
                </c:pt>
                <c:pt idx="43">
                  <c:v>0.15309709985266096</c:v>
                </c:pt>
                <c:pt idx="44">
                  <c:v>3.2012474572163323E-2</c:v>
                </c:pt>
                <c:pt idx="45">
                  <c:v>2.6186905252159554E-2</c:v>
                </c:pt>
                <c:pt idx="46">
                  <c:v>2.6186905252159554E-2</c:v>
                </c:pt>
                <c:pt idx="47">
                  <c:v>2.6186905252159554E-2</c:v>
                </c:pt>
                <c:pt idx="48">
                  <c:v>2.6186905252159554E-2</c:v>
                </c:pt>
                <c:pt idx="49">
                  <c:v>2.6186905252159554E-2</c:v>
                </c:pt>
                <c:pt idx="50">
                  <c:v>2.6186905252159554E-2</c:v>
                </c:pt>
                <c:pt idx="51">
                  <c:v>2.6186905252159554E-2</c:v>
                </c:pt>
                <c:pt idx="52">
                  <c:v>2.6186905252159554E-2</c:v>
                </c:pt>
                <c:pt idx="53">
                  <c:v>2.6186905252159554E-2</c:v>
                </c:pt>
                <c:pt idx="54">
                  <c:v>2.6186905252159554E-2</c:v>
                </c:pt>
                <c:pt idx="55">
                  <c:v>2.6186905252159554E-2</c:v>
                </c:pt>
                <c:pt idx="56">
                  <c:v>2.1050335023796832E-2</c:v>
                </c:pt>
                <c:pt idx="57">
                  <c:v>2.1050335023796832E-2</c:v>
                </c:pt>
                <c:pt idx="58">
                  <c:v>2.1050335023796832E-2</c:v>
                </c:pt>
                <c:pt idx="59">
                  <c:v>2.1050335023796832E-2</c:v>
                </c:pt>
                <c:pt idx="60">
                  <c:v>1.6210546164990996E-2</c:v>
                </c:pt>
                <c:pt idx="61">
                  <c:v>1.6210546164990996E-2</c:v>
                </c:pt>
                <c:pt idx="62">
                  <c:v>1.6210546164990996E-2</c:v>
                </c:pt>
                <c:pt idx="63">
                  <c:v>1.6210546164990996E-2</c:v>
                </c:pt>
                <c:pt idx="64">
                  <c:v>1.6210546164990996E-2</c:v>
                </c:pt>
                <c:pt idx="65">
                  <c:v>1.6210546164990996E-2</c:v>
                </c:pt>
                <c:pt idx="66">
                  <c:v>1.6210546164990996E-2</c:v>
                </c:pt>
                <c:pt idx="67">
                  <c:v>1.1714762875025734E-2</c:v>
                </c:pt>
                <c:pt idx="68">
                  <c:v>1.1714762875025734E-2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EB-47EF-A220-038E835644C1}"/>
            </c:ext>
          </c:extLst>
        </c:ser>
        <c:ser>
          <c:idx val="1"/>
          <c:order val="1"/>
          <c:spPr>
            <a:solidFill>
              <a:srgbClr val="7030A0"/>
            </a:solidFill>
            <a:ln>
              <a:noFill/>
            </a:ln>
            <a:effectLst/>
          </c:spPr>
          <c:cat>
            <c:numRef>
              <c:f>Лист3!$D$2:$D$223</c:f>
              <c:numCache>
                <c:formatCode>General</c:formatCode>
                <c:ptCount val="2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</c:numCache>
            </c:numRef>
          </c:cat>
          <c:val>
            <c:numRef>
              <c:f>Лист3!$B$2:$B$223</c:f>
              <c:numCache>
                <c:formatCode>General</c:formatCode>
                <c:ptCount val="2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3.2910667986686716E-2</c:v>
                </c:pt>
                <c:pt idx="158">
                  <c:v>3.2910667986686716E-2</c:v>
                </c:pt>
                <c:pt idx="159">
                  <c:v>3.2910667986686716E-2</c:v>
                </c:pt>
                <c:pt idx="160">
                  <c:v>3.2910667986686716E-2</c:v>
                </c:pt>
                <c:pt idx="161">
                  <c:v>3.2910667986686716E-2</c:v>
                </c:pt>
                <c:pt idx="162">
                  <c:v>3.2910667986686716E-2</c:v>
                </c:pt>
                <c:pt idx="163">
                  <c:v>3.2910667986686716E-2</c:v>
                </c:pt>
                <c:pt idx="164">
                  <c:v>3.2910667986686716E-2</c:v>
                </c:pt>
                <c:pt idx="165">
                  <c:v>3.2910667986686716E-2</c:v>
                </c:pt>
                <c:pt idx="166">
                  <c:v>3.2910667986686716E-2</c:v>
                </c:pt>
                <c:pt idx="167">
                  <c:v>3.2910667986686716E-2</c:v>
                </c:pt>
                <c:pt idx="168">
                  <c:v>3.2910667986686716E-2</c:v>
                </c:pt>
                <c:pt idx="169">
                  <c:v>3.2910667986686716E-2</c:v>
                </c:pt>
                <c:pt idx="170">
                  <c:v>3.2910667986686716E-2</c:v>
                </c:pt>
                <c:pt idx="171">
                  <c:v>3.2910667986686716E-2</c:v>
                </c:pt>
                <c:pt idx="172">
                  <c:v>3.2910667986686716E-2</c:v>
                </c:pt>
                <c:pt idx="173">
                  <c:v>3.2910667986686716E-2</c:v>
                </c:pt>
                <c:pt idx="174">
                  <c:v>2.7889254651049425E-2</c:v>
                </c:pt>
                <c:pt idx="175">
                  <c:v>2.2023673169799866E-2</c:v>
                </c:pt>
                <c:pt idx="176">
                  <c:v>1.9641771500724877E-2</c:v>
                </c:pt>
                <c:pt idx="177">
                  <c:v>1.9641771500724877E-2</c:v>
                </c:pt>
                <c:pt idx="178">
                  <c:v>3.1036059851125203E-2</c:v>
                </c:pt>
                <c:pt idx="179">
                  <c:v>3.1036059851125203E-2</c:v>
                </c:pt>
                <c:pt idx="180">
                  <c:v>3.1036059851125203E-2</c:v>
                </c:pt>
                <c:pt idx="181">
                  <c:v>3.1036059851125203E-2</c:v>
                </c:pt>
                <c:pt idx="182">
                  <c:v>3.1036059851125203E-2</c:v>
                </c:pt>
                <c:pt idx="183">
                  <c:v>3.1036059851125203E-2</c:v>
                </c:pt>
                <c:pt idx="184">
                  <c:v>3.1036059851125203E-2</c:v>
                </c:pt>
                <c:pt idx="185">
                  <c:v>3.1036059851125203E-2</c:v>
                </c:pt>
                <c:pt idx="186">
                  <c:v>3.1036059851125203E-2</c:v>
                </c:pt>
                <c:pt idx="187">
                  <c:v>3.1036059851125203E-2</c:v>
                </c:pt>
                <c:pt idx="188">
                  <c:v>3.1036059851125203E-2</c:v>
                </c:pt>
                <c:pt idx="189">
                  <c:v>3.1036059851125203E-2</c:v>
                </c:pt>
                <c:pt idx="190">
                  <c:v>3.1036059851125203E-2</c:v>
                </c:pt>
                <c:pt idx="191">
                  <c:v>3.1036059851125203E-2</c:v>
                </c:pt>
                <c:pt idx="192">
                  <c:v>3.1036059851125203E-2</c:v>
                </c:pt>
                <c:pt idx="193">
                  <c:v>3.1036059851125203E-2</c:v>
                </c:pt>
                <c:pt idx="194">
                  <c:v>3.1036059851125203E-2</c:v>
                </c:pt>
                <c:pt idx="195">
                  <c:v>1.2064074343867337E-2</c:v>
                </c:pt>
                <c:pt idx="196">
                  <c:v>1.2064074343867337E-2</c:v>
                </c:pt>
                <c:pt idx="197">
                  <c:v>1.2064074343867337E-2</c:v>
                </c:pt>
                <c:pt idx="198">
                  <c:v>1.2064074343867337E-2</c:v>
                </c:pt>
                <c:pt idx="199">
                  <c:v>1.2064074343867337E-2</c:v>
                </c:pt>
                <c:pt idx="200">
                  <c:v>1.2064074343867337E-2</c:v>
                </c:pt>
                <c:pt idx="201">
                  <c:v>1.2064074343867337E-2</c:v>
                </c:pt>
                <c:pt idx="202">
                  <c:v>9.6306506752948853E-3</c:v>
                </c:pt>
                <c:pt idx="203">
                  <c:v>1.8294273052329706E-2</c:v>
                </c:pt>
                <c:pt idx="204">
                  <c:v>1.8294273052329706E-2</c:v>
                </c:pt>
                <c:pt idx="205">
                  <c:v>1.8294273052329706E-2</c:v>
                </c:pt>
                <c:pt idx="206">
                  <c:v>1.8294273052329706E-2</c:v>
                </c:pt>
                <c:pt idx="207">
                  <c:v>1.8294273052329706E-2</c:v>
                </c:pt>
                <c:pt idx="208">
                  <c:v>1.8294273052329706E-2</c:v>
                </c:pt>
                <c:pt idx="209">
                  <c:v>1.8294273052329706E-2</c:v>
                </c:pt>
                <c:pt idx="210">
                  <c:v>1.8294273052329706E-2</c:v>
                </c:pt>
                <c:pt idx="211">
                  <c:v>1.8294273052329706E-2</c:v>
                </c:pt>
                <c:pt idx="212">
                  <c:v>1.8294273052329706E-2</c:v>
                </c:pt>
                <c:pt idx="213">
                  <c:v>1.8294273052329706E-2</c:v>
                </c:pt>
                <c:pt idx="214">
                  <c:v>1.8294273052329706E-2</c:v>
                </c:pt>
                <c:pt idx="215">
                  <c:v>1.8294273052329706E-2</c:v>
                </c:pt>
                <c:pt idx="216">
                  <c:v>1.8294273052329706E-2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EB-47EF-A220-038E835644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8436656"/>
        <c:axId val="488461616"/>
      </c:areaChart>
      <c:catAx>
        <c:axId val="488436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488461616"/>
        <c:crosses val="autoZero"/>
        <c:auto val="1"/>
        <c:lblAlgn val="ctr"/>
        <c:lblOffset val="100"/>
        <c:noMultiLvlLbl val="0"/>
      </c:catAx>
      <c:valAx>
        <c:axId val="488461616"/>
        <c:scaling>
          <c:orientation val="minMax"/>
          <c:max val="1.0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488436656"/>
        <c:crosses val="autoZero"/>
        <c:crossBetween val="midCat"/>
        <c:majorUnit val="0.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areaChart>
        <c:grouping val="standar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cat>
            <c:numRef>
              <c:f>Лист3!$O$2:$O$223</c:f>
              <c:numCache>
                <c:formatCode>General</c:formatCode>
                <c:ptCount val="2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</c:numCache>
            </c:numRef>
          </c:cat>
          <c:val>
            <c:numRef>
              <c:f>Лист3!$N$2:$N$223</c:f>
              <c:numCache>
                <c:formatCode>General</c:formatCode>
                <c:ptCount val="222"/>
                <c:pt idx="0">
                  <c:v>1.0000000475315995</c:v>
                </c:pt>
                <c:pt idx="1">
                  <c:v>1.0000000475315995</c:v>
                </c:pt>
                <c:pt idx="2">
                  <c:v>1.0000000475315995</c:v>
                </c:pt>
                <c:pt idx="3">
                  <c:v>1.0000000475315995</c:v>
                </c:pt>
                <c:pt idx="4">
                  <c:v>1.0000000475315995</c:v>
                </c:pt>
                <c:pt idx="5">
                  <c:v>1.0000000475315995</c:v>
                </c:pt>
                <c:pt idx="6">
                  <c:v>1.0000000475315995</c:v>
                </c:pt>
                <c:pt idx="7">
                  <c:v>1.0000000475315995</c:v>
                </c:pt>
                <c:pt idx="8">
                  <c:v>1.0000000475315995</c:v>
                </c:pt>
                <c:pt idx="9">
                  <c:v>1.0000000475315995</c:v>
                </c:pt>
                <c:pt idx="10">
                  <c:v>1.0000000475315995</c:v>
                </c:pt>
                <c:pt idx="11">
                  <c:v>1.0000000475315995</c:v>
                </c:pt>
                <c:pt idx="12">
                  <c:v>1.0000000475315995</c:v>
                </c:pt>
                <c:pt idx="13">
                  <c:v>1.0000000475315995</c:v>
                </c:pt>
                <c:pt idx="14">
                  <c:v>1.0000000475315995</c:v>
                </c:pt>
                <c:pt idx="15">
                  <c:v>1.0000000475315995</c:v>
                </c:pt>
                <c:pt idx="16">
                  <c:v>1.0000000475315995</c:v>
                </c:pt>
                <c:pt idx="17">
                  <c:v>1.0000000475315995</c:v>
                </c:pt>
                <c:pt idx="18">
                  <c:v>1.0000000475315995</c:v>
                </c:pt>
                <c:pt idx="19">
                  <c:v>1.0000000475315995</c:v>
                </c:pt>
                <c:pt idx="20">
                  <c:v>1.0000000475315995</c:v>
                </c:pt>
                <c:pt idx="21">
                  <c:v>1.0000000475315995</c:v>
                </c:pt>
                <c:pt idx="22">
                  <c:v>1.0000000475315995</c:v>
                </c:pt>
                <c:pt idx="23">
                  <c:v>1.0000000475315995</c:v>
                </c:pt>
                <c:pt idx="24">
                  <c:v>1.0000000475315995</c:v>
                </c:pt>
                <c:pt idx="25">
                  <c:v>1.0000000475315995</c:v>
                </c:pt>
                <c:pt idx="26">
                  <c:v>1.0000000475315995</c:v>
                </c:pt>
                <c:pt idx="27">
                  <c:v>0.99704856845974865</c:v>
                </c:pt>
                <c:pt idx="28">
                  <c:v>0.99486037511834347</c:v>
                </c:pt>
                <c:pt idx="29">
                  <c:v>0.99272866169356755</c:v>
                </c:pt>
                <c:pt idx="30">
                  <c:v>0.98871697390099156</c:v>
                </c:pt>
                <c:pt idx="31">
                  <c:v>0.97353517231106568</c:v>
                </c:pt>
                <c:pt idx="32">
                  <c:v>0.97068697080105093</c:v>
                </c:pt>
                <c:pt idx="33">
                  <c:v>0.96723201361524835</c:v>
                </c:pt>
                <c:pt idx="34">
                  <c:v>0.9570962891481648</c:v>
                </c:pt>
                <c:pt idx="35">
                  <c:v>0.9570962891481648</c:v>
                </c:pt>
                <c:pt idx="36">
                  <c:v>0.95414158265250637</c:v>
                </c:pt>
                <c:pt idx="37">
                  <c:v>0.93503846113661127</c:v>
                </c:pt>
                <c:pt idx="38">
                  <c:v>0.93503846113661127</c:v>
                </c:pt>
                <c:pt idx="39">
                  <c:v>0.93503846113661127</c:v>
                </c:pt>
                <c:pt idx="40">
                  <c:v>0.93503846113661127</c:v>
                </c:pt>
                <c:pt idx="41">
                  <c:v>0.82203989879254624</c:v>
                </c:pt>
                <c:pt idx="42">
                  <c:v>0.82203989879254624</c:v>
                </c:pt>
                <c:pt idx="43">
                  <c:v>0.71833939030447691</c:v>
                </c:pt>
                <c:pt idx="44">
                  <c:v>0.55886728950521658</c:v>
                </c:pt>
                <c:pt idx="45">
                  <c:v>0.49145981662626154</c:v>
                </c:pt>
                <c:pt idx="46">
                  <c:v>0.45140112123425341</c:v>
                </c:pt>
                <c:pt idx="47">
                  <c:v>0.43601345522609847</c:v>
                </c:pt>
                <c:pt idx="48">
                  <c:v>0.42364039819563409</c:v>
                </c:pt>
                <c:pt idx="49">
                  <c:v>0.4201173353720955</c:v>
                </c:pt>
                <c:pt idx="50">
                  <c:v>0.4201173353720955</c:v>
                </c:pt>
                <c:pt idx="51">
                  <c:v>0.40691753075600673</c:v>
                </c:pt>
                <c:pt idx="52">
                  <c:v>0.40691753075600673</c:v>
                </c:pt>
                <c:pt idx="53">
                  <c:v>0.40067448469851935</c:v>
                </c:pt>
                <c:pt idx="54">
                  <c:v>0.39144131379717045</c:v>
                </c:pt>
                <c:pt idx="55">
                  <c:v>0.37596693314837132</c:v>
                </c:pt>
                <c:pt idx="56">
                  <c:v>0.33687617718040136</c:v>
                </c:pt>
                <c:pt idx="57">
                  <c:v>0.29378736619261109</c:v>
                </c:pt>
                <c:pt idx="58">
                  <c:v>0.28377009090538974</c:v>
                </c:pt>
                <c:pt idx="59">
                  <c:v>0.27509168966971531</c:v>
                </c:pt>
                <c:pt idx="60">
                  <c:v>0.2456264628477034</c:v>
                </c:pt>
                <c:pt idx="61">
                  <c:v>0.22079485835282195</c:v>
                </c:pt>
                <c:pt idx="62">
                  <c:v>0.22079485835282195</c:v>
                </c:pt>
                <c:pt idx="63">
                  <c:v>0.22079485835282195</c:v>
                </c:pt>
                <c:pt idx="64">
                  <c:v>0.22079485835282195</c:v>
                </c:pt>
                <c:pt idx="65">
                  <c:v>0.18832644848223967</c:v>
                </c:pt>
                <c:pt idx="66">
                  <c:v>0.18832644848223967</c:v>
                </c:pt>
                <c:pt idx="67">
                  <c:v>0.11835915941146694</c:v>
                </c:pt>
                <c:pt idx="68">
                  <c:v>9.8140773798858494E-2</c:v>
                </c:pt>
                <c:pt idx="69">
                  <c:v>2.2484800267375753E-2</c:v>
                </c:pt>
                <c:pt idx="70">
                  <c:v>7.7371903243995599E-3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55-486D-9178-18E4CA839EC6}"/>
            </c:ext>
          </c:extLst>
        </c:ser>
        <c:ser>
          <c:idx val="1"/>
          <c:order val="1"/>
          <c:spPr>
            <a:solidFill>
              <a:srgbClr val="7030A0"/>
            </a:solidFill>
            <a:ln>
              <a:noFill/>
            </a:ln>
            <a:effectLst/>
          </c:spPr>
          <c:cat>
            <c:numRef>
              <c:f>Лист3!$O$2:$O$223</c:f>
              <c:numCache>
                <c:formatCode>General</c:formatCode>
                <c:ptCount val="2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</c:numCache>
            </c:numRef>
          </c:cat>
          <c:val>
            <c:numRef>
              <c:f>Лист3!$M$2:$M$223</c:f>
              <c:numCache>
                <c:formatCode>General</c:formatCode>
                <c:ptCount val="2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2.2495143937453816E-3</c:v>
                </c:pt>
                <c:pt idx="80">
                  <c:v>5.6641287819557311E-3</c:v>
                </c:pt>
                <c:pt idx="81">
                  <c:v>5.6641287819557311E-3</c:v>
                </c:pt>
                <c:pt idx="82">
                  <c:v>5.6641287819557311E-3</c:v>
                </c:pt>
                <c:pt idx="83">
                  <c:v>5.6641287819557311E-3</c:v>
                </c:pt>
                <c:pt idx="84">
                  <c:v>5.6641287819557311E-3</c:v>
                </c:pt>
                <c:pt idx="85">
                  <c:v>5.6641287819557311E-3</c:v>
                </c:pt>
                <c:pt idx="86">
                  <c:v>5.6641287819557311E-3</c:v>
                </c:pt>
                <c:pt idx="87">
                  <c:v>5.6641287819557311E-3</c:v>
                </c:pt>
                <c:pt idx="88">
                  <c:v>5.6641287819557311E-3</c:v>
                </c:pt>
                <c:pt idx="89">
                  <c:v>1.2128658668142243E-2</c:v>
                </c:pt>
                <c:pt idx="90">
                  <c:v>1.804936764278486E-2</c:v>
                </c:pt>
                <c:pt idx="91">
                  <c:v>1.804936764278486E-2</c:v>
                </c:pt>
                <c:pt idx="92">
                  <c:v>1.804936764278486E-2</c:v>
                </c:pt>
                <c:pt idx="93">
                  <c:v>1.804936764278486E-2</c:v>
                </c:pt>
                <c:pt idx="94">
                  <c:v>2.3126105291797032E-2</c:v>
                </c:pt>
                <c:pt idx="95">
                  <c:v>2.3126105291797032E-2</c:v>
                </c:pt>
                <c:pt idx="96">
                  <c:v>2.3126105291797032E-2</c:v>
                </c:pt>
                <c:pt idx="97">
                  <c:v>2.3126105291797032E-2</c:v>
                </c:pt>
                <c:pt idx="98">
                  <c:v>2.3126105291797032E-2</c:v>
                </c:pt>
                <c:pt idx="99">
                  <c:v>3.1974087659735285E-2</c:v>
                </c:pt>
                <c:pt idx="100">
                  <c:v>3.5196670331406395E-2</c:v>
                </c:pt>
                <c:pt idx="101">
                  <c:v>3.5196670331406395E-2</c:v>
                </c:pt>
                <c:pt idx="102">
                  <c:v>3.5196670331406395E-2</c:v>
                </c:pt>
                <c:pt idx="103">
                  <c:v>3.2966520480505308E-2</c:v>
                </c:pt>
                <c:pt idx="104">
                  <c:v>3.2966520480505308E-2</c:v>
                </c:pt>
                <c:pt idx="105">
                  <c:v>3.2966520480505308E-2</c:v>
                </c:pt>
                <c:pt idx="106">
                  <c:v>3.2966520480505308E-2</c:v>
                </c:pt>
                <c:pt idx="107">
                  <c:v>3.2966520480505308E-2</c:v>
                </c:pt>
                <c:pt idx="108">
                  <c:v>3.2966520480505308E-2</c:v>
                </c:pt>
                <c:pt idx="109">
                  <c:v>3.2966520480505308E-2</c:v>
                </c:pt>
                <c:pt idx="110">
                  <c:v>3.2966520480505308E-2</c:v>
                </c:pt>
                <c:pt idx="111">
                  <c:v>3.2966520480505308E-2</c:v>
                </c:pt>
                <c:pt idx="112">
                  <c:v>2.7539607348392166E-2</c:v>
                </c:pt>
                <c:pt idx="113">
                  <c:v>2.7539607348392166E-2</c:v>
                </c:pt>
                <c:pt idx="114">
                  <c:v>2.7539607348392166E-2</c:v>
                </c:pt>
                <c:pt idx="115">
                  <c:v>2.7539607348392166E-2</c:v>
                </c:pt>
                <c:pt idx="116">
                  <c:v>2.7539607348392166E-2</c:v>
                </c:pt>
                <c:pt idx="117">
                  <c:v>2.7539607348392166E-2</c:v>
                </c:pt>
                <c:pt idx="118">
                  <c:v>2.7539607348392166E-2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2.8995175485521534E-2</c:v>
                </c:pt>
                <c:pt idx="155">
                  <c:v>3.4225215765384363E-2</c:v>
                </c:pt>
                <c:pt idx="156">
                  <c:v>4.8048271932402249E-2</c:v>
                </c:pt>
                <c:pt idx="157">
                  <c:v>9.8910857424841764E-2</c:v>
                </c:pt>
                <c:pt idx="158">
                  <c:v>0.10251588981768767</c:v>
                </c:pt>
                <c:pt idx="159">
                  <c:v>0.10251588981768767</c:v>
                </c:pt>
                <c:pt idx="160">
                  <c:v>0.10251588981768767</c:v>
                </c:pt>
                <c:pt idx="161">
                  <c:v>0.10251588981768767</c:v>
                </c:pt>
                <c:pt idx="162">
                  <c:v>0.10251588981768767</c:v>
                </c:pt>
                <c:pt idx="163">
                  <c:v>0.10251588981768767</c:v>
                </c:pt>
                <c:pt idx="164">
                  <c:v>0.10251588981768767</c:v>
                </c:pt>
                <c:pt idx="165">
                  <c:v>0.10595148246064599</c:v>
                </c:pt>
                <c:pt idx="166">
                  <c:v>0.10595148246064599</c:v>
                </c:pt>
                <c:pt idx="167">
                  <c:v>0.10595148246064599</c:v>
                </c:pt>
                <c:pt idx="168">
                  <c:v>0.10595148246064599</c:v>
                </c:pt>
                <c:pt idx="169">
                  <c:v>0.10595148246064599</c:v>
                </c:pt>
                <c:pt idx="170">
                  <c:v>0.11108631373819106</c:v>
                </c:pt>
                <c:pt idx="171">
                  <c:v>0.11108631373819106</c:v>
                </c:pt>
                <c:pt idx="172">
                  <c:v>0.11108631373819106</c:v>
                </c:pt>
                <c:pt idx="173">
                  <c:v>0.11108631373819106</c:v>
                </c:pt>
                <c:pt idx="174">
                  <c:v>9.9964611297952047E-2</c:v>
                </c:pt>
                <c:pt idx="175">
                  <c:v>9.0711587242187322E-2</c:v>
                </c:pt>
                <c:pt idx="176">
                  <c:v>8.5625167321753001E-2</c:v>
                </c:pt>
                <c:pt idx="177">
                  <c:v>7.930587150689869E-2</c:v>
                </c:pt>
                <c:pt idx="178">
                  <c:v>8.9825659407060915E-2</c:v>
                </c:pt>
                <c:pt idx="179">
                  <c:v>9.3533969361743047E-2</c:v>
                </c:pt>
                <c:pt idx="180">
                  <c:v>9.3533969361743047E-2</c:v>
                </c:pt>
                <c:pt idx="181">
                  <c:v>9.3533969361743047E-2</c:v>
                </c:pt>
                <c:pt idx="182">
                  <c:v>9.3533969361743047E-2</c:v>
                </c:pt>
                <c:pt idx="183">
                  <c:v>9.3533969361743047E-2</c:v>
                </c:pt>
                <c:pt idx="184">
                  <c:v>9.3533969361743047E-2</c:v>
                </c:pt>
                <c:pt idx="185">
                  <c:v>9.3533969361743047E-2</c:v>
                </c:pt>
                <c:pt idx="186">
                  <c:v>9.3533969361743047E-2</c:v>
                </c:pt>
                <c:pt idx="187">
                  <c:v>9.3533969361743047E-2</c:v>
                </c:pt>
                <c:pt idx="188">
                  <c:v>9.3533969361743047E-2</c:v>
                </c:pt>
                <c:pt idx="189">
                  <c:v>9.3533969361743047E-2</c:v>
                </c:pt>
                <c:pt idx="190">
                  <c:v>9.3533969361743047E-2</c:v>
                </c:pt>
                <c:pt idx="191">
                  <c:v>9.3533969361743047E-2</c:v>
                </c:pt>
                <c:pt idx="192">
                  <c:v>9.3533969361743047E-2</c:v>
                </c:pt>
                <c:pt idx="193">
                  <c:v>9.3533969361743047E-2</c:v>
                </c:pt>
                <c:pt idx="194">
                  <c:v>9.3533969361743047E-2</c:v>
                </c:pt>
                <c:pt idx="195">
                  <c:v>4.7998246863387828E-2</c:v>
                </c:pt>
                <c:pt idx="196">
                  <c:v>4.7998246863387828E-2</c:v>
                </c:pt>
                <c:pt idx="197">
                  <c:v>4.7998246863387828E-2</c:v>
                </c:pt>
                <c:pt idx="198">
                  <c:v>4.7998246863387828E-2</c:v>
                </c:pt>
                <c:pt idx="199">
                  <c:v>4.7998246863387828E-2</c:v>
                </c:pt>
                <c:pt idx="200">
                  <c:v>4.7998246863387828E-2</c:v>
                </c:pt>
                <c:pt idx="201">
                  <c:v>5.0447861533190905E-2</c:v>
                </c:pt>
                <c:pt idx="202">
                  <c:v>9.1155358015702376E-2</c:v>
                </c:pt>
                <c:pt idx="203">
                  <c:v>0.10132012929705256</c:v>
                </c:pt>
                <c:pt idx="204">
                  <c:v>0.10132012929705256</c:v>
                </c:pt>
                <c:pt idx="205">
                  <c:v>0.10132012929705256</c:v>
                </c:pt>
                <c:pt idx="206">
                  <c:v>0.10132012929705256</c:v>
                </c:pt>
                <c:pt idx="207">
                  <c:v>0.10132012929705256</c:v>
                </c:pt>
                <c:pt idx="208">
                  <c:v>0.10132012929705256</c:v>
                </c:pt>
                <c:pt idx="209">
                  <c:v>0.10132012929705256</c:v>
                </c:pt>
                <c:pt idx="210">
                  <c:v>0.10132012929705256</c:v>
                </c:pt>
                <c:pt idx="211">
                  <c:v>0.10132012929705256</c:v>
                </c:pt>
                <c:pt idx="212">
                  <c:v>0.10132012929705256</c:v>
                </c:pt>
                <c:pt idx="213">
                  <c:v>0.10132012929705256</c:v>
                </c:pt>
                <c:pt idx="214">
                  <c:v>0.10132012929705256</c:v>
                </c:pt>
                <c:pt idx="215">
                  <c:v>9.4557062708683193E-2</c:v>
                </c:pt>
                <c:pt idx="216">
                  <c:v>9.4557062708683193E-2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55-486D-9178-18E4CA839E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8442896"/>
        <c:axId val="488437488"/>
      </c:areaChart>
      <c:catAx>
        <c:axId val="488442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488437488"/>
        <c:crosses val="autoZero"/>
        <c:auto val="1"/>
        <c:lblAlgn val="ctr"/>
        <c:lblOffset val="100"/>
        <c:noMultiLvlLbl val="0"/>
      </c:catAx>
      <c:valAx>
        <c:axId val="488437488"/>
        <c:scaling>
          <c:orientation val="minMax"/>
          <c:max val="1.0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488442896"/>
        <c:crosses val="autoZero"/>
        <c:crossBetween val="midCat"/>
        <c:majorUnit val="0.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373669417060462"/>
          <c:y val="0.12427410401662445"/>
          <c:w val="0.82801374542594797"/>
          <c:h val="0.75145179196675116"/>
        </c:manualLayout>
      </c:layout>
      <c:areaChart>
        <c:grouping val="standard"/>
        <c:varyColors val="0"/>
        <c:ser>
          <c:idx val="0"/>
          <c:order val="0"/>
          <c:spPr>
            <a:solidFill>
              <a:srgbClr val="7030A0"/>
            </a:solidFill>
            <a:ln>
              <a:noFill/>
            </a:ln>
            <a:effectLst/>
          </c:spPr>
          <c:cat>
            <c:numRef>
              <c:f>Лист3!$A$2:$A$223</c:f>
              <c:numCache>
                <c:formatCode>General</c:formatCode>
                <c:ptCount val="2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0</c:v>
                </c:pt>
                <c:pt idx="221">
                  <c:v>220</c:v>
                </c:pt>
              </c:numCache>
            </c:numRef>
          </c:cat>
          <c:val>
            <c:numRef>
              <c:f>Лист3!$B$2:$B$223</c:f>
              <c:numCache>
                <c:formatCode>General</c:formatCode>
                <c:ptCount val="2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8.1758981555972304E-3</c:v>
                </c:pt>
                <c:pt idx="90">
                  <c:v>1.4894395750577815E-2</c:v>
                </c:pt>
                <c:pt idx="91">
                  <c:v>1.4894395750577815E-2</c:v>
                </c:pt>
                <c:pt idx="92">
                  <c:v>1.4894395750577815E-2</c:v>
                </c:pt>
                <c:pt idx="93">
                  <c:v>1.4894395750577815E-2</c:v>
                </c:pt>
                <c:pt idx="94">
                  <c:v>1.9352093564499011E-2</c:v>
                </c:pt>
                <c:pt idx="95">
                  <c:v>1.9352093564499011E-2</c:v>
                </c:pt>
                <c:pt idx="96">
                  <c:v>1.9352093564499011E-2</c:v>
                </c:pt>
                <c:pt idx="97">
                  <c:v>1.9352093564499011E-2</c:v>
                </c:pt>
                <c:pt idx="98">
                  <c:v>1.9352093564499011E-2</c:v>
                </c:pt>
                <c:pt idx="99">
                  <c:v>1.9352093564499011E-2</c:v>
                </c:pt>
                <c:pt idx="100">
                  <c:v>1.9352093564499011E-2</c:v>
                </c:pt>
                <c:pt idx="101">
                  <c:v>1.9352093564499011E-2</c:v>
                </c:pt>
                <c:pt idx="102">
                  <c:v>1.9352093564499011E-2</c:v>
                </c:pt>
                <c:pt idx="103">
                  <c:v>1.9352093564499011E-2</c:v>
                </c:pt>
                <c:pt idx="104">
                  <c:v>1.9352093564499011E-2</c:v>
                </c:pt>
                <c:pt idx="105">
                  <c:v>1.9352093564499011E-2</c:v>
                </c:pt>
                <c:pt idx="106">
                  <c:v>1.9352093564499011E-2</c:v>
                </c:pt>
                <c:pt idx="107">
                  <c:v>1.9352093564499011E-2</c:v>
                </c:pt>
                <c:pt idx="108">
                  <c:v>1.9352093564499011E-2</c:v>
                </c:pt>
                <c:pt idx="109">
                  <c:v>1.9352093564499011E-2</c:v>
                </c:pt>
                <c:pt idx="110">
                  <c:v>1.9352093564499011E-2</c:v>
                </c:pt>
                <c:pt idx="111">
                  <c:v>1.9352093564499011E-2</c:v>
                </c:pt>
                <c:pt idx="112">
                  <c:v>1.9352093564499011E-2</c:v>
                </c:pt>
                <c:pt idx="113">
                  <c:v>1.9352093564499011E-2</c:v>
                </c:pt>
                <c:pt idx="114">
                  <c:v>1.9352093564499011E-2</c:v>
                </c:pt>
                <c:pt idx="115">
                  <c:v>1.9352093564499011E-2</c:v>
                </c:pt>
                <c:pt idx="116">
                  <c:v>1.9352093564499011E-2</c:v>
                </c:pt>
                <c:pt idx="117">
                  <c:v>1.9352093564499011E-2</c:v>
                </c:pt>
                <c:pt idx="118">
                  <c:v>1.9352093564499011E-2</c:v>
                </c:pt>
                <c:pt idx="119">
                  <c:v>4.6910493702703067E-3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6F-45F7-B471-4051938B66EC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cat>
            <c:numRef>
              <c:f>Лист3!$A$2:$A$223</c:f>
              <c:numCache>
                <c:formatCode>General</c:formatCode>
                <c:ptCount val="2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0</c:v>
                </c:pt>
                <c:pt idx="221">
                  <c:v>220</c:v>
                </c:pt>
              </c:numCache>
            </c:numRef>
          </c:cat>
          <c:val>
            <c:numRef>
              <c:f>Лист3!$C$2:$C$223</c:f>
              <c:numCache>
                <c:formatCode>General</c:formatCode>
                <c:ptCount val="22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0.99507471766995714</c:v>
                </c:pt>
                <c:pt idx="32">
                  <c:v>0.99507471766995714</c:v>
                </c:pt>
                <c:pt idx="33">
                  <c:v>0.99507471766995714</c:v>
                </c:pt>
                <c:pt idx="34">
                  <c:v>0.9885862663684879</c:v>
                </c:pt>
                <c:pt idx="35">
                  <c:v>0.9885862663684879</c:v>
                </c:pt>
                <c:pt idx="36">
                  <c:v>0.98312487040615293</c:v>
                </c:pt>
                <c:pt idx="37">
                  <c:v>0.96140356443951447</c:v>
                </c:pt>
                <c:pt idx="38">
                  <c:v>0.96140356443951447</c:v>
                </c:pt>
                <c:pt idx="39">
                  <c:v>0.96140356443951447</c:v>
                </c:pt>
                <c:pt idx="40">
                  <c:v>0.96140356443951447</c:v>
                </c:pt>
                <c:pt idx="41">
                  <c:v>0.51641735069081096</c:v>
                </c:pt>
                <c:pt idx="42">
                  <c:v>0.51641735069081096</c:v>
                </c:pt>
                <c:pt idx="43">
                  <c:v>0.48006981596516868</c:v>
                </c:pt>
                <c:pt idx="44">
                  <c:v>0.34396746563683489</c:v>
                </c:pt>
                <c:pt idx="45">
                  <c:v>0.32683849185704428</c:v>
                </c:pt>
                <c:pt idx="46">
                  <c:v>0.32018323495769374</c:v>
                </c:pt>
                <c:pt idx="47">
                  <c:v>0.32018323495769374</c:v>
                </c:pt>
                <c:pt idx="48">
                  <c:v>0.31754563521312446</c:v>
                </c:pt>
                <c:pt idx="49">
                  <c:v>0.31754563521312446</c:v>
                </c:pt>
                <c:pt idx="50">
                  <c:v>0.31754563521312446</c:v>
                </c:pt>
                <c:pt idx="51">
                  <c:v>0.3121880245038966</c:v>
                </c:pt>
                <c:pt idx="52">
                  <c:v>0.3121880245038966</c:v>
                </c:pt>
                <c:pt idx="53">
                  <c:v>0.3121880245038966</c:v>
                </c:pt>
                <c:pt idx="54">
                  <c:v>0.30640337383602417</c:v>
                </c:pt>
                <c:pt idx="55">
                  <c:v>0.29927259978974119</c:v>
                </c:pt>
                <c:pt idx="56">
                  <c:v>0.27068229659357407</c:v>
                </c:pt>
                <c:pt idx="57">
                  <c:v>0.24079082159359061</c:v>
                </c:pt>
                <c:pt idx="58">
                  <c:v>0.23424309591189668</c:v>
                </c:pt>
                <c:pt idx="59">
                  <c:v>0.22395513480294132</c:v>
                </c:pt>
                <c:pt idx="60">
                  <c:v>0.19593840488456149</c:v>
                </c:pt>
                <c:pt idx="61">
                  <c:v>0.17234654050258064</c:v>
                </c:pt>
                <c:pt idx="62">
                  <c:v>0.17234654050258064</c:v>
                </c:pt>
                <c:pt idx="63">
                  <c:v>0.17234654050258064</c:v>
                </c:pt>
                <c:pt idx="64">
                  <c:v>0.17234654050258064</c:v>
                </c:pt>
                <c:pt idx="65">
                  <c:v>0.15389127492140636</c:v>
                </c:pt>
                <c:pt idx="66">
                  <c:v>0.15389127492140636</c:v>
                </c:pt>
                <c:pt idx="67">
                  <c:v>0.12942880430794737</c:v>
                </c:pt>
                <c:pt idx="68">
                  <c:v>0.11463290538993617</c:v>
                </c:pt>
                <c:pt idx="69">
                  <c:v>2.1762731927538942E-2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6F-45F7-B471-4051938B66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8465776"/>
        <c:axId val="488449968"/>
      </c:areaChart>
      <c:catAx>
        <c:axId val="488465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488449968"/>
        <c:crosses val="autoZero"/>
        <c:auto val="1"/>
        <c:lblAlgn val="ctr"/>
        <c:lblOffset val="100"/>
        <c:noMultiLvlLbl val="0"/>
      </c:catAx>
      <c:valAx>
        <c:axId val="488449968"/>
        <c:scaling>
          <c:orientation val="minMax"/>
          <c:max val="1.0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488465776"/>
        <c:crosses val="autoZero"/>
        <c:crossBetween val="midCat"/>
        <c:majorUnit val="0.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54181"/>
            <a:ext cx="10363200" cy="564623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18153"/>
            <a:ext cx="9144000" cy="391557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766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70634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3453"/>
            <a:ext cx="2628900" cy="13743921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3453"/>
            <a:ext cx="7734300" cy="13743921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58283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67449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43217"/>
            <a:ext cx="10515600" cy="6746195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53234"/>
            <a:ext cx="10515600" cy="354766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24736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17265"/>
            <a:ext cx="5181600" cy="1029010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17265"/>
            <a:ext cx="5181600" cy="1029010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1221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3457"/>
            <a:ext cx="10515600" cy="3134711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75639"/>
            <a:ext cx="5157787" cy="194839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24039"/>
            <a:ext cx="5157787" cy="871336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75639"/>
            <a:ext cx="5183188" cy="194839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24039"/>
            <a:ext cx="5183188" cy="871336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897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55121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17150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1193"/>
            <a:ext cx="3932237" cy="378417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35081"/>
            <a:ext cx="6172200" cy="1152522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5370"/>
            <a:ext cx="3932237" cy="9013700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34090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1193"/>
            <a:ext cx="3932237" cy="378417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35081"/>
            <a:ext cx="6172200" cy="1152522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ru-RU" smtClean="0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5370"/>
            <a:ext cx="3932237" cy="9013700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42927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3457"/>
            <a:ext cx="10515600" cy="31347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17265"/>
            <a:ext cx="10515600" cy="102901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31594"/>
            <a:ext cx="27432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8C5BB-B180-47DC-8991-EB585F277454}" type="datetimeFigureOut">
              <a:rPr lang="ru-RU" smtClean="0"/>
              <a:t>11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31594"/>
            <a:ext cx="41148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31594"/>
            <a:ext cx="27432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43737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3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Группа 3"/>
          <p:cNvGrpSpPr/>
          <p:nvPr/>
        </p:nvGrpSpPr>
        <p:grpSpPr>
          <a:xfrm>
            <a:off x="716414" y="359960"/>
            <a:ext cx="8282109" cy="4239601"/>
            <a:chOff x="716414" y="359960"/>
            <a:chExt cx="8282109" cy="4239601"/>
          </a:xfrm>
        </p:grpSpPr>
        <p:grpSp>
          <p:nvGrpSpPr>
            <p:cNvPr id="12" name="Группа 11"/>
            <p:cNvGrpSpPr/>
            <p:nvPr/>
          </p:nvGrpSpPr>
          <p:grpSpPr>
            <a:xfrm>
              <a:off x="716414" y="359960"/>
              <a:ext cx="8282109" cy="4239601"/>
              <a:chOff x="716414" y="359960"/>
              <a:chExt cx="8282109" cy="4239601"/>
            </a:xfrm>
          </p:grpSpPr>
          <p:grpSp>
            <p:nvGrpSpPr>
              <p:cNvPr id="11" name="Группа 10"/>
              <p:cNvGrpSpPr/>
              <p:nvPr/>
            </p:nvGrpSpPr>
            <p:grpSpPr>
              <a:xfrm>
                <a:off x="716414" y="359960"/>
                <a:ext cx="3522651" cy="4239601"/>
                <a:chOff x="716414" y="359960"/>
                <a:chExt cx="3522651" cy="4239601"/>
              </a:xfrm>
            </p:grpSpPr>
            <p:graphicFrame>
              <p:nvGraphicFramePr>
                <p:cNvPr id="49" name="Диаграмма 4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501289503"/>
                    </p:ext>
                  </p:extLst>
                </p:nvPr>
              </p:nvGraphicFramePr>
              <p:xfrm>
                <a:off x="1166067" y="589986"/>
                <a:ext cx="2905872" cy="114385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cxnSp>
              <p:nvCxnSpPr>
                <p:cNvPr id="50" name="Прямая соединительная линия 49"/>
                <p:cNvCxnSpPr/>
                <p:nvPr/>
              </p:nvCxnSpPr>
              <p:spPr>
                <a:xfrm>
                  <a:off x="1334648" y="588027"/>
                  <a:ext cx="43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Прямая соединительная линия 50"/>
                <p:cNvCxnSpPr/>
                <p:nvPr/>
              </p:nvCxnSpPr>
              <p:spPr>
                <a:xfrm>
                  <a:off x="1777777" y="629896"/>
                  <a:ext cx="39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" name="TextBox 51"/>
                <p:cNvSpPr txBox="1"/>
                <p:nvPr/>
              </p:nvSpPr>
              <p:spPr>
                <a:xfrm>
                  <a:off x="1200792" y="359960"/>
                  <a:ext cx="64472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/>
                    <a:t>Core 1A</a:t>
                  </a:r>
                  <a:endParaRPr lang="ru-RU" sz="1100" b="1" dirty="0"/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1716270" y="407564"/>
                  <a:ext cx="63831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/>
                    <a:t>Core 1B</a:t>
                  </a:r>
                  <a:endParaRPr lang="ru-RU" sz="1100" b="1" dirty="0"/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2662522" y="467362"/>
                  <a:ext cx="7312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/>
                    <a:t>Cores 2-4</a:t>
                  </a:r>
                  <a:endParaRPr lang="ru-RU" sz="1100" b="1" dirty="0"/>
                </a:p>
              </p:txBody>
            </p:sp>
            <p:cxnSp>
              <p:nvCxnSpPr>
                <p:cNvPr id="55" name="Прямая соединительная линия 54"/>
                <p:cNvCxnSpPr/>
                <p:nvPr/>
              </p:nvCxnSpPr>
              <p:spPr>
                <a:xfrm>
                  <a:off x="2138990" y="69388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" name="TextBox 55"/>
                <p:cNvSpPr txBox="1"/>
                <p:nvPr/>
              </p:nvSpPr>
              <p:spPr>
                <a:xfrm>
                  <a:off x="988089" y="640619"/>
                  <a:ext cx="3497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.0</a:t>
                  </a:r>
                  <a:endParaRPr lang="en-US" sz="800" b="1" dirty="0"/>
                </a:p>
              </p:txBody>
            </p:sp>
            <p:sp>
              <p:nvSpPr>
                <p:cNvPr id="57" name="Прямоугольник 56"/>
                <p:cNvSpPr/>
                <p:nvPr/>
              </p:nvSpPr>
              <p:spPr>
                <a:xfrm>
                  <a:off x="988089" y="1057749"/>
                  <a:ext cx="34977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 dirty="0"/>
                    <a:t>0.5</a:t>
                  </a: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1058166" y="1468568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0</a:t>
                  </a:r>
                  <a:endParaRPr lang="ru-RU" sz="1000" b="1" dirty="0"/>
                </a:p>
              </p:txBody>
            </p:sp>
            <p:sp>
              <p:nvSpPr>
                <p:cNvPr id="59" name="Полилиния 58"/>
                <p:cNvSpPr/>
                <p:nvPr/>
              </p:nvSpPr>
              <p:spPr>
                <a:xfrm>
                  <a:off x="1218074" y="1614338"/>
                  <a:ext cx="3020991" cy="241899"/>
                </a:xfrm>
                <a:custGeom>
                  <a:avLst/>
                  <a:gdLst>
                    <a:gd name="f0" fmla="val w"/>
                    <a:gd name="f1" fmla="val h"/>
                    <a:gd name="f2" fmla="val 0"/>
                    <a:gd name="f3" fmla="val 21600"/>
                    <a:gd name="f4" fmla="*/ f0 1 21600"/>
                    <a:gd name="f5" fmla="*/ f1 1 21600"/>
                    <a:gd name="f6" fmla="+- f3 0 f2"/>
                    <a:gd name="f7" fmla="*/ f6 1 21600"/>
                    <a:gd name="f8" fmla="*/ f2 1 f7"/>
                    <a:gd name="f9" fmla="*/ f3 1 f7"/>
                    <a:gd name="f10" fmla="*/ f8 f4 1"/>
                    <a:gd name="f11" fmla="*/ f9 f4 1"/>
                    <a:gd name="f12" fmla="*/ f9 f5 1"/>
                    <a:gd name="f13" fmla="*/ f8 f5 1"/>
                  </a:gdLst>
                  <a:ahLst/>
                  <a:cxnLst>
                    <a:cxn ang="3cd4">
                      <a:pos x="hc" y="t"/>
                    </a:cxn>
                    <a:cxn ang="0">
                      <a:pos x="r" y="vc"/>
                    </a:cxn>
                    <a:cxn ang="cd4">
                      <a:pos x="hc" y="b"/>
                    </a:cxn>
                    <a:cxn ang="cd2">
                      <a:pos x="l" y="vc"/>
                    </a:cxn>
                  </a:cxnLst>
                  <a:rect l="f10" t="f13" r="f11" b="f12"/>
                  <a:pathLst>
                    <a:path w="21600" h="21600">
                      <a:moveTo>
                        <a:pt x="f2" y="f2"/>
                      </a:moveTo>
                      <a:lnTo>
                        <a:pt x="f3" y="f2"/>
                      </a:lnTo>
                      <a:lnTo>
                        <a:pt x="f3" y="f3"/>
                      </a:lnTo>
                      <a:lnTo>
                        <a:pt x="f2" y="f3"/>
                      </a:lnTo>
                      <a:lnTo>
                        <a:pt x="f2" y="f2"/>
                      </a:lnTo>
                      <a:close/>
                    </a:path>
                  </a:pathLst>
                </a:custGeom>
                <a:noFill/>
                <a:ln cap="flat">
                  <a:noFill/>
                  <a:prstDash val="solid"/>
                </a:ln>
              </p:spPr>
              <p:txBody>
                <a:bodyPr vert="horz" wrap="square" lIns="90004" tIns="44997" rIns="90004" bIns="44997" anchor="t" anchorCtr="0" compatLnSpc="1">
                  <a:noAutofit/>
                </a:bodyPr>
                <a:lstStyle/>
                <a:p>
                  <a:pPr marL="0" marR="0" lvl="0" indent="0" algn="l" defTabSz="914400" rtl="0" fontAlgn="auto" hangingPunct="0">
                    <a:lnSpc>
                      <a:spcPct val="93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>
                      <a:tab pos="0" algn="l"/>
                      <a:tab pos="448915" algn="l"/>
                      <a:tab pos="898196" algn="l"/>
                      <a:tab pos="1347478" algn="l"/>
                      <a:tab pos="1796759" algn="l"/>
                      <a:tab pos="2246040" algn="l"/>
                      <a:tab pos="2695322" algn="l"/>
                      <a:tab pos="3144603" algn="l"/>
                      <a:tab pos="3593875" algn="l"/>
                      <a:tab pos="4043156" algn="l"/>
                      <a:tab pos="4492438" algn="l"/>
                      <a:tab pos="4941719" algn="l"/>
                      <a:tab pos="5391000" algn="l"/>
                      <a:tab pos="5840281" algn="l"/>
                      <a:tab pos="6289563" algn="l"/>
                      <a:tab pos="6738844" algn="l"/>
                      <a:tab pos="7188116" algn="l"/>
                      <a:tab pos="7637397" algn="l"/>
                      <a:tab pos="8086679" algn="l"/>
                      <a:tab pos="8535960" algn="l"/>
                      <a:tab pos="8985241" algn="l"/>
                    </a:tabLst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2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30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60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90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2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5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8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222   </a:t>
                  </a:r>
                </a:p>
              </p:txBody>
            </p:sp>
            <p:sp>
              <p:nvSpPr>
                <p:cNvPr id="63" name="Прямоугольник 62"/>
                <p:cNvSpPr/>
                <p:nvPr/>
              </p:nvSpPr>
              <p:spPr>
                <a:xfrm>
                  <a:off x="2308286" y="824498"/>
                  <a:ext cx="1514849" cy="499134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64" name="Прямоугольник 63"/>
                <p:cNvSpPr/>
                <p:nvPr/>
              </p:nvSpPr>
              <p:spPr>
                <a:xfrm>
                  <a:off x="1927126" y="833179"/>
                  <a:ext cx="2285421" cy="49244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[</a:t>
                  </a:r>
                  <a:r>
                    <a:rPr lang="ru-RU" altLang="ru-RU" sz="11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SI</a:t>
                  </a:r>
                  <a:r>
                    <a:rPr lang="ru-RU" altLang="ru-RU" sz="1100" b="1" i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]</a:t>
                  </a:r>
                  <a:r>
                    <a:rPr lang="en-US" altLang="ru-RU" sz="1100" b="1" baseline="-8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eak </a:t>
                  </a:r>
                  <a:r>
                    <a:rPr lang="en-US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 </a:t>
                  </a:r>
                  <a:r>
                    <a:rPr lang="en-US" altLang="ru-RU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solate #</a:t>
                  </a:r>
                  <a:r>
                    <a:rPr lang="en-US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US" altLang="ru-RU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US" altLang="ru-RU" sz="400" b="1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Δ</a:t>
                  </a:r>
                  <a:r>
                    <a:rPr lang="ru-RU" altLang="ru-RU" sz="11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nq1</a:t>
                  </a:r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train</a:t>
                  </a:r>
                  <a:endParaRPr lang="ru-RU" altLang="ru-RU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65" name="Диаграмма 6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157841321"/>
                    </p:ext>
                  </p:extLst>
                </p:nvPr>
              </p:nvGraphicFramePr>
              <p:xfrm>
                <a:off x="1151402" y="1725553"/>
                <a:ext cx="2908236" cy="113691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71" name="Прямоугольник 70"/>
                <p:cNvSpPr/>
                <p:nvPr/>
              </p:nvSpPr>
              <p:spPr>
                <a:xfrm>
                  <a:off x="2308286" y="1945747"/>
                  <a:ext cx="1514849" cy="499134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72" name="Прямоугольник 71"/>
                <p:cNvSpPr/>
                <p:nvPr/>
              </p:nvSpPr>
              <p:spPr>
                <a:xfrm>
                  <a:off x="1927126" y="1954428"/>
                  <a:ext cx="2285421" cy="49244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[</a:t>
                  </a:r>
                  <a:r>
                    <a:rPr lang="ru-RU" altLang="ru-RU" sz="11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SI</a:t>
                  </a:r>
                  <a:r>
                    <a:rPr lang="ru-RU" altLang="ru-RU" sz="1100" b="1" i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]</a:t>
                  </a:r>
                  <a:r>
                    <a:rPr lang="en-US" altLang="ru-RU" sz="1100" b="1" baseline="-8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eak </a:t>
                  </a:r>
                  <a:r>
                    <a:rPr lang="en-US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 </a:t>
                  </a:r>
                  <a:r>
                    <a:rPr lang="en-US" altLang="ru-RU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solate </a:t>
                  </a:r>
                  <a:r>
                    <a:rPr lang="en-US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r>
                    <a:rPr lang="en-US" altLang="ru-RU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  <a:p>
                  <a:pPr algn="ctr"/>
                  <a:endParaRPr lang="en-US" altLang="ru-RU" sz="400" b="1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Δ</a:t>
                  </a:r>
                  <a:r>
                    <a:rPr lang="ru-RU" altLang="ru-RU" sz="11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nq1</a:t>
                  </a:r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train</a:t>
                  </a:r>
                  <a:endParaRPr lang="ru-RU" altLang="ru-RU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Полилиния 72"/>
                <p:cNvSpPr/>
                <p:nvPr/>
              </p:nvSpPr>
              <p:spPr>
                <a:xfrm>
                  <a:off x="1208427" y="2715859"/>
                  <a:ext cx="3020991" cy="241899"/>
                </a:xfrm>
                <a:custGeom>
                  <a:avLst/>
                  <a:gdLst>
                    <a:gd name="f0" fmla="val w"/>
                    <a:gd name="f1" fmla="val h"/>
                    <a:gd name="f2" fmla="val 0"/>
                    <a:gd name="f3" fmla="val 21600"/>
                    <a:gd name="f4" fmla="*/ f0 1 21600"/>
                    <a:gd name="f5" fmla="*/ f1 1 21600"/>
                    <a:gd name="f6" fmla="+- f3 0 f2"/>
                    <a:gd name="f7" fmla="*/ f6 1 21600"/>
                    <a:gd name="f8" fmla="*/ f2 1 f7"/>
                    <a:gd name="f9" fmla="*/ f3 1 f7"/>
                    <a:gd name="f10" fmla="*/ f8 f4 1"/>
                    <a:gd name="f11" fmla="*/ f9 f4 1"/>
                    <a:gd name="f12" fmla="*/ f9 f5 1"/>
                    <a:gd name="f13" fmla="*/ f8 f5 1"/>
                  </a:gdLst>
                  <a:ahLst/>
                  <a:cxnLst>
                    <a:cxn ang="3cd4">
                      <a:pos x="hc" y="t"/>
                    </a:cxn>
                    <a:cxn ang="0">
                      <a:pos x="r" y="vc"/>
                    </a:cxn>
                    <a:cxn ang="cd4">
                      <a:pos x="hc" y="b"/>
                    </a:cxn>
                    <a:cxn ang="cd2">
                      <a:pos x="l" y="vc"/>
                    </a:cxn>
                  </a:cxnLst>
                  <a:rect l="f10" t="f13" r="f11" b="f12"/>
                  <a:pathLst>
                    <a:path w="21600" h="21600">
                      <a:moveTo>
                        <a:pt x="f2" y="f2"/>
                      </a:moveTo>
                      <a:lnTo>
                        <a:pt x="f3" y="f2"/>
                      </a:lnTo>
                      <a:lnTo>
                        <a:pt x="f3" y="f3"/>
                      </a:lnTo>
                      <a:lnTo>
                        <a:pt x="f2" y="f3"/>
                      </a:lnTo>
                      <a:lnTo>
                        <a:pt x="f2" y="f2"/>
                      </a:lnTo>
                      <a:close/>
                    </a:path>
                  </a:pathLst>
                </a:custGeom>
                <a:noFill/>
                <a:ln cap="flat">
                  <a:noFill/>
                  <a:prstDash val="solid"/>
                </a:ln>
              </p:spPr>
              <p:txBody>
                <a:bodyPr vert="horz" wrap="square" lIns="90004" tIns="44997" rIns="90004" bIns="44997" anchor="t" anchorCtr="0" compatLnSpc="1">
                  <a:noAutofit/>
                </a:bodyPr>
                <a:lstStyle/>
                <a:p>
                  <a:pPr marL="0" marR="0" lvl="0" indent="0" algn="l" defTabSz="914400" rtl="0" fontAlgn="auto" hangingPunct="0">
                    <a:lnSpc>
                      <a:spcPct val="93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>
                      <a:tab pos="0" algn="l"/>
                      <a:tab pos="448915" algn="l"/>
                      <a:tab pos="898196" algn="l"/>
                      <a:tab pos="1347478" algn="l"/>
                      <a:tab pos="1796759" algn="l"/>
                      <a:tab pos="2246040" algn="l"/>
                      <a:tab pos="2695322" algn="l"/>
                      <a:tab pos="3144603" algn="l"/>
                      <a:tab pos="3593875" algn="l"/>
                      <a:tab pos="4043156" algn="l"/>
                      <a:tab pos="4492438" algn="l"/>
                      <a:tab pos="4941719" algn="l"/>
                      <a:tab pos="5391000" algn="l"/>
                      <a:tab pos="5840281" algn="l"/>
                      <a:tab pos="6289563" algn="l"/>
                      <a:tab pos="6738844" algn="l"/>
                      <a:tab pos="7188116" algn="l"/>
                      <a:tab pos="7637397" algn="l"/>
                      <a:tab pos="8086679" algn="l"/>
                      <a:tab pos="8535960" algn="l"/>
                      <a:tab pos="8985241" algn="l"/>
                    </a:tabLst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2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30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60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90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2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5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8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222   </a:t>
                  </a: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978442" y="1788437"/>
                  <a:ext cx="3497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.0</a:t>
                  </a:r>
                  <a:endParaRPr lang="en-US" sz="800" b="1" dirty="0"/>
                </a:p>
              </p:txBody>
            </p:sp>
            <p:sp>
              <p:nvSpPr>
                <p:cNvPr id="75" name="Прямоугольник 74"/>
                <p:cNvSpPr/>
                <p:nvPr/>
              </p:nvSpPr>
              <p:spPr>
                <a:xfrm>
                  <a:off x="978442" y="2193992"/>
                  <a:ext cx="34977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 dirty="0"/>
                    <a:t>0.5</a:t>
                  </a: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1048519" y="2616386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0</a:t>
                  </a:r>
                  <a:endParaRPr lang="ru-RU" sz="1000" b="1" dirty="0"/>
                </a:p>
              </p:txBody>
            </p:sp>
            <p:graphicFrame>
              <p:nvGraphicFramePr>
                <p:cNvPr id="77" name="Диаграмма 7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46159273"/>
                    </p:ext>
                  </p:extLst>
                </p:nvPr>
              </p:nvGraphicFramePr>
              <p:xfrm>
                <a:off x="901060" y="3199785"/>
                <a:ext cx="3158578" cy="112412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78" name="Полилиния 77"/>
                <p:cNvSpPr/>
                <p:nvPr/>
              </p:nvSpPr>
              <p:spPr>
                <a:xfrm>
                  <a:off x="1210352" y="4187780"/>
                  <a:ext cx="3020991" cy="241899"/>
                </a:xfrm>
                <a:custGeom>
                  <a:avLst/>
                  <a:gdLst>
                    <a:gd name="f0" fmla="val w"/>
                    <a:gd name="f1" fmla="val h"/>
                    <a:gd name="f2" fmla="val 0"/>
                    <a:gd name="f3" fmla="val 21600"/>
                    <a:gd name="f4" fmla="*/ f0 1 21600"/>
                    <a:gd name="f5" fmla="*/ f1 1 21600"/>
                    <a:gd name="f6" fmla="+- f3 0 f2"/>
                    <a:gd name="f7" fmla="*/ f6 1 21600"/>
                    <a:gd name="f8" fmla="*/ f2 1 f7"/>
                    <a:gd name="f9" fmla="*/ f3 1 f7"/>
                    <a:gd name="f10" fmla="*/ f8 f4 1"/>
                    <a:gd name="f11" fmla="*/ f9 f4 1"/>
                    <a:gd name="f12" fmla="*/ f9 f5 1"/>
                    <a:gd name="f13" fmla="*/ f8 f5 1"/>
                  </a:gdLst>
                  <a:ahLst/>
                  <a:cxnLst>
                    <a:cxn ang="3cd4">
                      <a:pos x="hc" y="t"/>
                    </a:cxn>
                    <a:cxn ang="0">
                      <a:pos x="r" y="vc"/>
                    </a:cxn>
                    <a:cxn ang="cd4">
                      <a:pos x="hc" y="b"/>
                    </a:cxn>
                    <a:cxn ang="cd2">
                      <a:pos x="l" y="vc"/>
                    </a:cxn>
                  </a:cxnLst>
                  <a:rect l="f10" t="f13" r="f11" b="f12"/>
                  <a:pathLst>
                    <a:path w="21600" h="21600">
                      <a:moveTo>
                        <a:pt x="f2" y="f2"/>
                      </a:moveTo>
                      <a:lnTo>
                        <a:pt x="f3" y="f2"/>
                      </a:lnTo>
                      <a:lnTo>
                        <a:pt x="f3" y="f3"/>
                      </a:lnTo>
                      <a:lnTo>
                        <a:pt x="f2" y="f3"/>
                      </a:lnTo>
                      <a:lnTo>
                        <a:pt x="f2" y="f2"/>
                      </a:lnTo>
                      <a:close/>
                    </a:path>
                  </a:pathLst>
                </a:custGeom>
                <a:noFill/>
                <a:ln cap="flat">
                  <a:noFill/>
                  <a:prstDash val="solid"/>
                </a:ln>
              </p:spPr>
              <p:txBody>
                <a:bodyPr vert="horz" wrap="square" lIns="90004" tIns="44997" rIns="90004" bIns="44997" anchor="t" anchorCtr="0" compatLnSpc="1">
                  <a:noAutofit/>
                </a:bodyPr>
                <a:lstStyle/>
                <a:p>
                  <a:pPr marL="0" marR="0" lvl="0" indent="0" algn="l" defTabSz="914400" rtl="0" fontAlgn="auto" hangingPunct="0">
                    <a:lnSpc>
                      <a:spcPct val="93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>
                      <a:tab pos="0" algn="l"/>
                      <a:tab pos="448915" algn="l"/>
                      <a:tab pos="898196" algn="l"/>
                      <a:tab pos="1347478" algn="l"/>
                      <a:tab pos="1796759" algn="l"/>
                      <a:tab pos="2246040" algn="l"/>
                      <a:tab pos="2695322" algn="l"/>
                      <a:tab pos="3144603" algn="l"/>
                      <a:tab pos="3593875" algn="l"/>
                      <a:tab pos="4043156" algn="l"/>
                      <a:tab pos="4492438" algn="l"/>
                      <a:tab pos="4941719" algn="l"/>
                      <a:tab pos="5391000" algn="l"/>
                      <a:tab pos="5840281" algn="l"/>
                      <a:tab pos="6289563" algn="l"/>
                      <a:tab pos="6738844" algn="l"/>
                      <a:tab pos="7188116" algn="l"/>
                      <a:tab pos="7637397" algn="l"/>
                      <a:tab pos="8086679" algn="l"/>
                      <a:tab pos="8535960" algn="l"/>
                      <a:tab pos="8985241" algn="l"/>
                    </a:tabLst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2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30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60 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90 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2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5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180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en-US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  </a:t>
                  </a:r>
                  <a:r>
                    <a:rPr lang="ru-RU" sz="8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8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itchFamily="18"/>
                      <a:ea typeface="Microsoft YaHei" pitchFamily="2"/>
                      <a:cs typeface="Microsoft YaHei" pitchFamily="2"/>
                    </a:rPr>
                    <a:t>222   </a:t>
                  </a:r>
                </a:p>
              </p:txBody>
            </p:sp>
            <p:sp>
              <p:nvSpPr>
                <p:cNvPr id="80" name="Прямоугольник 79"/>
                <p:cNvSpPr/>
                <p:nvPr/>
              </p:nvSpPr>
              <p:spPr>
                <a:xfrm>
                  <a:off x="2678565" y="3452389"/>
                  <a:ext cx="1030748" cy="499134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79" name="Прямоугольник 78"/>
                <p:cNvSpPr/>
                <p:nvPr/>
              </p:nvSpPr>
              <p:spPr>
                <a:xfrm>
                  <a:off x="2655705" y="3451900"/>
                  <a:ext cx="1106393" cy="4924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[</a:t>
                  </a:r>
                  <a:r>
                    <a:rPr lang="ru-RU" altLang="ru-RU" sz="11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SI</a:t>
                  </a:r>
                  <a:r>
                    <a:rPr lang="ru-RU" altLang="ru-RU" sz="1100" b="1" i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]</a:t>
                  </a:r>
                  <a:r>
                    <a:rPr lang="en-US" altLang="ru-RU" sz="1100" b="1" baseline="-8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eak</a:t>
                  </a:r>
                  <a:endParaRPr lang="en-US" altLang="ru-RU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US" altLang="ru-RU" sz="400" b="1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[</a:t>
                  </a:r>
                  <a:r>
                    <a:rPr lang="ru-RU" altLang="ru-RU" sz="11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NQ</a:t>
                  </a:r>
                  <a:r>
                    <a:rPr lang="ru-RU" altLang="ru-RU" sz="1100" b="1" i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] </a:t>
                  </a:r>
                  <a:r>
                    <a:rPr lang="en-US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train</a:t>
                  </a:r>
                  <a:r>
                    <a:rPr lang="ru-RU" altLang="ru-RU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endParaRPr lang="ru-RU" altLang="ru-RU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" name="Прямоугольник 2"/>
                <p:cNvSpPr/>
                <p:nvPr/>
              </p:nvSpPr>
              <p:spPr>
                <a:xfrm>
                  <a:off x="924210" y="3247130"/>
                  <a:ext cx="305439" cy="105363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980371" y="3237206"/>
                  <a:ext cx="3497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.0</a:t>
                  </a:r>
                  <a:endParaRPr lang="en-US" sz="800" b="1" dirty="0"/>
                </a:p>
              </p:txBody>
            </p:sp>
            <p:sp>
              <p:nvSpPr>
                <p:cNvPr id="82" name="Прямоугольник 81"/>
                <p:cNvSpPr/>
                <p:nvPr/>
              </p:nvSpPr>
              <p:spPr>
                <a:xfrm>
                  <a:off x="980371" y="3642761"/>
                  <a:ext cx="34977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 dirty="0"/>
                    <a:t>0.5</a:t>
                  </a: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1050448" y="4065155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0</a:t>
                  </a:r>
                  <a:endParaRPr lang="ru-RU" sz="1000" b="1" dirty="0"/>
                </a:p>
              </p:txBody>
            </p:sp>
            <p:sp>
              <p:nvSpPr>
                <p:cNvPr id="84" name="Прямоугольник 83"/>
                <p:cNvSpPr/>
                <p:nvPr/>
              </p:nvSpPr>
              <p:spPr>
                <a:xfrm>
                  <a:off x="1527498" y="4335514"/>
                  <a:ext cx="2056973" cy="26404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hangingPunct="0">
                    <a:lnSpc>
                      <a:spcPct val="93000"/>
                    </a:lnSpc>
                    <a:tabLst>
                      <a:tab pos="0" algn="l"/>
                      <a:tab pos="448915" algn="l"/>
                      <a:tab pos="898196" algn="l"/>
                      <a:tab pos="1347478" algn="l"/>
                      <a:tab pos="1796759" algn="l"/>
                      <a:tab pos="2246040" algn="l"/>
                      <a:tab pos="2695322" algn="l"/>
                      <a:tab pos="3144603" algn="l"/>
                      <a:tab pos="3593875" algn="l"/>
                      <a:tab pos="4043156" algn="l"/>
                      <a:tab pos="4492438" algn="l"/>
                      <a:tab pos="4941719" algn="l"/>
                      <a:tab pos="5391000" algn="l"/>
                      <a:tab pos="5840281" algn="l"/>
                      <a:tab pos="6289563" algn="l"/>
                      <a:tab pos="6738844" algn="l"/>
                      <a:tab pos="7188116" algn="l"/>
                      <a:tab pos="7637397" algn="l"/>
                      <a:tab pos="8086679" algn="l"/>
                      <a:tab pos="8535960" algn="l"/>
                      <a:tab pos="8985241" algn="l"/>
                    </a:tabLst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ru-RU" sz="1200" b="1" dirty="0" smtClean="0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Sup35</a:t>
                  </a:r>
                  <a:r>
                    <a:rPr lang="en-US" sz="1200" b="1" dirty="0" smtClean="0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PD</a:t>
                  </a:r>
                  <a:r>
                    <a:rPr lang="ru-RU" sz="1200" b="1" dirty="0" smtClean="0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1200" b="1" dirty="0" err="1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amino</a:t>
                  </a:r>
                  <a:r>
                    <a:rPr lang="ru-RU" sz="1200" b="1" dirty="0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1200" b="1" dirty="0" err="1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acid</a:t>
                  </a:r>
                  <a:r>
                    <a:rPr lang="ru-RU" sz="1200" b="1" dirty="0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1200" b="1" dirty="0" err="1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rPr>
                    <a:t>position</a:t>
                  </a:r>
                  <a:endParaRPr lang="ru-RU" sz="1200" b="1" dirty="0">
                    <a:solidFill>
                      <a:srgbClr val="000000"/>
                    </a:solidFill>
                    <a:ea typeface="Microsoft YaHei" pitchFamily="2"/>
                    <a:cs typeface="Microsoft YaHei" pitchFamily="2"/>
                  </a:endParaRPr>
                </a:p>
              </p:txBody>
            </p:sp>
            <p:sp>
              <p:nvSpPr>
                <p:cNvPr id="86" name="Полилиния 85"/>
                <p:cNvSpPr/>
                <p:nvPr/>
              </p:nvSpPr>
              <p:spPr>
                <a:xfrm rot="16200000">
                  <a:off x="-62671" y="1903657"/>
                  <a:ext cx="1944361" cy="386191"/>
                </a:xfrm>
                <a:custGeom>
                  <a:avLst/>
                  <a:gdLst>
                    <a:gd name="f0" fmla="val w"/>
                    <a:gd name="f1" fmla="val h"/>
                    <a:gd name="f2" fmla="val 0"/>
                    <a:gd name="f3" fmla="val 21600"/>
                    <a:gd name="f4" fmla="*/ f0 1 21600"/>
                    <a:gd name="f5" fmla="*/ f1 1 21600"/>
                    <a:gd name="f6" fmla="+- f3 0 f2"/>
                    <a:gd name="f7" fmla="*/ f6 1 21600"/>
                    <a:gd name="f8" fmla="*/ f2 1 f7"/>
                    <a:gd name="f9" fmla="*/ f3 1 f7"/>
                    <a:gd name="f10" fmla="*/ f8 f4 1"/>
                    <a:gd name="f11" fmla="*/ f9 f4 1"/>
                    <a:gd name="f12" fmla="*/ f9 f5 1"/>
                    <a:gd name="f13" fmla="*/ f8 f5 1"/>
                  </a:gdLst>
                  <a:ahLst/>
                  <a:cxnLst>
                    <a:cxn ang="3cd4">
                      <a:pos x="hc" y="t"/>
                    </a:cxn>
                    <a:cxn ang="0">
                      <a:pos x="r" y="vc"/>
                    </a:cxn>
                    <a:cxn ang="cd4">
                      <a:pos x="hc" y="b"/>
                    </a:cxn>
                    <a:cxn ang="cd2">
                      <a:pos x="l" y="vc"/>
                    </a:cxn>
                  </a:cxnLst>
                  <a:rect l="f10" t="f13" r="f11" b="f12"/>
                  <a:pathLst>
                    <a:path w="21600" h="21600">
                      <a:moveTo>
                        <a:pt x="f2" y="f2"/>
                      </a:moveTo>
                      <a:lnTo>
                        <a:pt x="f3" y="f2"/>
                      </a:lnTo>
                      <a:lnTo>
                        <a:pt x="f3" y="f3"/>
                      </a:lnTo>
                      <a:lnTo>
                        <a:pt x="f2" y="f3"/>
                      </a:lnTo>
                      <a:lnTo>
                        <a:pt x="f2" y="f2"/>
                      </a:lnTo>
                      <a:close/>
                    </a:path>
                  </a:pathLst>
                </a:custGeom>
                <a:noFill/>
                <a:ln cap="flat">
                  <a:noFill/>
                  <a:prstDash val="solid"/>
                </a:ln>
              </p:spPr>
              <p:txBody>
                <a:bodyPr vert="horz" wrap="square" lIns="90004" tIns="44997" rIns="90004" bIns="44997" anchor="t" anchorCtr="0" compatLnSpc="1">
                  <a:noAutofit/>
                </a:bodyPr>
                <a:lstStyle/>
                <a:p>
                  <a:pPr marL="0" marR="0" lvl="0" indent="0" algn="l" defTabSz="914400" rtl="0" fontAlgn="auto" hangingPunct="0">
                    <a:lnSpc>
                      <a:spcPct val="93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>
                      <a:tab pos="0" algn="l"/>
                      <a:tab pos="448915" algn="l"/>
                      <a:tab pos="898196" algn="l"/>
                      <a:tab pos="1347478" algn="l"/>
                      <a:tab pos="1796759" algn="l"/>
                      <a:tab pos="2246040" algn="l"/>
                      <a:tab pos="2695322" algn="l"/>
                      <a:tab pos="3144603" algn="l"/>
                      <a:tab pos="3593875" algn="l"/>
                      <a:tab pos="4043156" algn="l"/>
                      <a:tab pos="4492438" algn="l"/>
                      <a:tab pos="4941719" algn="l"/>
                      <a:tab pos="5391000" algn="l"/>
                      <a:tab pos="5840281" algn="l"/>
                      <a:tab pos="6289563" algn="l"/>
                      <a:tab pos="6738844" algn="l"/>
                      <a:tab pos="7188116" algn="l"/>
                      <a:tab pos="7637397" algn="l"/>
                      <a:tab pos="8086679" algn="l"/>
                      <a:tab pos="8535960" algn="l"/>
                      <a:tab pos="8985241" algn="l"/>
                    </a:tabLst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ru-RU" sz="1200" b="1" i="0" u="none" strike="noStrike" kern="1200" cap="none" spc="0" baseline="0" dirty="0" err="1">
                      <a:solidFill>
                        <a:srgbClr val="000000"/>
                      </a:solidFill>
                      <a:uFillTx/>
                      <a:ea typeface="Microsoft YaHei" pitchFamily="2"/>
                      <a:cs typeface="Microsoft YaHei" pitchFamily="2"/>
                    </a:rPr>
                    <a:t>PrK</a:t>
                  </a:r>
                  <a:r>
                    <a:rPr lang="ru-RU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1200" b="1" i="0" u="none" strike="noStrike" kern="1200" cap="none" spc="0" baseline="0" dirty="0" err="1">
                      <a:solidFill>
                        <a:srgbClr val="000000"/>
                      </a:solidFill>
                      <a:uFillTx/>
                      <a:ea typeface="Microsoft YaHei" pitchFamily="2"/>
                      <a:cs typeface="Microsoft YaHei" pitchFamily="2"/>
                    </a:rPr>
                    <a:t>resistance</a:t>
                  </a:r>
                  <a:r>
                    <a:rPr lang="ru-RU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ea typeface="Microsoft YaHei" pitchFamily="2"/>
                      <a:cs typeface="Microsoft YaHei" pitchFamily="2"/>
                    </a:rPr>
                    <a:t> </a:t>
                  </a:r>
                  <a:r>
                    <a:rPr lang="ru-RU" sz="1200" b="1" i="0" u="none" strike="noStrike" kern="1200" cap="none" spc="0" baseline="0" dirty="0" err="1">
                      <a:solidFill>
                        <a:srgbClr val="000000"/>
                      </a:solidFill>
                      <a:uFillTx/>
                      <a:ea typeface="Microsoft YaHei" pitchFamily="2"/>
                      <a:cs typeface="Microsoft YaHei" pitchFamily="2"/>
                    </a:rPr>
                    <a:t>index</a:t>
                  </a:r>
                  <a:endParaRPr lang="ru-RU" sz="1200" b="1" i="0" u="none" strike="noStrike" kern="1200" cap="none" spc="0" baseline="0" dirty="0">
                    <a:solidFill>
                      <a:srgbClr val="000000"/>
                    </a:solidFill>
                    <a:uFillTx/>
                    <a:ea typeface="Microsoft YaHei" pitchFamily="2"/>
                    <a:cs typeface="Microsoft YaHei" pitchFamily="2"/>
                  </a:endParaRPr>
                </a:p>
              </p:txBody>
            </p:sp>
            <p:cxnSp>
              <p:nvCxnSpPr>
                <p:cNvPr id="87" name="Прямая соединительная линия 86"/>
                <p:cNvCxnSpPr/>
                <p:nvPr/>
              </p:nvCxnSpPr>
              <p:spPr>
                <a:xfrm>
                  <a:off x="995330" y="690693"/>
                  <a:ext cx="0" cy="3564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" name="Группа 9"/>
              <p:cNvGrpSpPr/>
              <p:nvPr/>
            </p:nvGrpSpPr>
            <p:grpSpPr>
              <a:xfrm>
                <a:off x="4082788" y="663842"/>
                <a:ext cx="4915735" cy="3881227"/>
                <a:chOff x="4082788" y="663842"/>
                <a:chExt cx="4915735" cy="3881227"/>
              </a:xfrm>
            </p:grpSpPr>
            <p:pic>
              <p:nvPicPr>
                <p:cNvPr id="8" name="Рисунок 7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2509" b="5362"/>
                <a:stretch/>
              </p:blipFill>
              <p:spPr>
                <a:xfrm>
                  <a:off x="4175760" y="1801585"/>
                  <a:ext cx="4511040" cy="979715"/>
                </a:xfrm>
                <a:prstGeom prst="rect">
                  <a:avLst/>
                </a:prstGeom>
              </p:spPr>
            </p:pic>
            <p:pic>
              <p:nvPicPr>
                <p:cNvPr id="9" name="Рисунок 8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4189055" y="673825"/>
                  <a:ext cx="4497745" cy="964475"/>
                </a:xfrm>
                <a:prstGeom prst="rect">
                  <a:avLst/>
                </a:prstGeom>
              </p:spPr>
            </p:pic>
            <p:cxnSp>
              <p:nvCxnSpPr>
                <p:cNvPr id="37" name="Прямая соединительная линия 36"/>
                <p:cNvCxnSpPr/>
                <p:nvPr/>
              </p:nvCxnSpPr>
              <p:spPr>
                <a:xfrm>
                  <a:off x="8735211" y="663842"/>
                  <a:ext cx="0" cy="3564000"/>
                </a:xfrm>
                <a:prstGeom prst="line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TextBox 37"/>
                <p:cNvSpPr txBox="1"/>
                <p:nvPr/>
              </p:nvSpPr>
              <p:spPr>
                <a:xfrm rot="16200000">
                  <a:off x="8301249" y="2408633"/>
                  <a:ext cx="11175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Intensity (</a:t>
                  </a:r>
                  <a:r>
                    <a:rPr lang="en-US" sz="1200" b="1" dirty="0" err="1" smtClean="0"/>
                    <a:t>a.u</a:t>
                  </a:r>
                  <a:r>
                    <a:rPr lang="en-US" sz="1200" b="1" dirty="0" smtClean="0"/>
                    <a:t>.)</a:t>
                  </a:r>
                  <a:endParaRPr lang="ru-RU" sz="1200" b="1" dirty="0"/>
                </a:p>
              </p:txBody>
            </p:sp>
            <p:pic>
              <p:nvPicPr>
                <p:cNvPr id="2" name="Рисунок 1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4183750" y="3324953"/>
                  <a:ext cx="4487810" cy="895445"/>
                </a:xfrm>
                <a:prstGeom prst="rect">
                  <a:avLst/>
                </a:prstGeom>
              </p:spPr>
            </p:pic>
            <p:sp>
              <p:nvSpPr>
                <p:cNvPr id="40" name="TextBox 39"/>
                <p:cNvSpPr txBox="1"/>
                <p:nvPr/>
              </p:nvSpPr>
              <p:spPr>
                <a:xfrm>
                  <a:off x="4082788" y="4243258"/>
                  <a:ext cx="43633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m/z</a:t>
                  </a:r>
                  <a:endParaRPr lang="ru-RU" sz="1200" b="1" dirty="0"/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 rot="2700000">
                  <a:off x="4616145" y="4235488"/>
                  <a:ext cx="36420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 smtClean="0"/>
                    <a:t>4000</a:t>
                  </a:r>
                  <a:endParaRPr lang="ru-RU" sz="700" b="1" dirty="0"/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 rot="2700000">
                  <a:off x="5388701" y="4247371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5000</a:t>
                  </a:r>
                  <a:endParaRPr lang="ru-RU" sz="700" b="1" dirty="0"/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 rot="2700000">
                  <a:off x="6187322" y="4247371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6000</a:t>
                  </a:r>
                  <a:endParaRPr lang="ru-RU" sz="700" b="1" dirty="0"/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 rot="2700000">
                  <a:off x="6967566" y="4246972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7000</a:t>
                  </a:r>
                  <a:endParaRPr lang="ru-RU" sz="700" b="1" dirty="0"/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 rot="2700000">
                  <a:off x="7774232" y="4242229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8000</a:t>
                  </a:r>
                  <a:endParaRPr lang="ru-RU" sz="700" b="1" dirty="0"/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4084714" y="2786776"/>
                  <a:ext cx="43633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m/z</a:t>
                  </a:r>
                  <a:endParaRPr lang="ru-RU" sz="1200" b="1" dirty="0"/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 rot="2700000">
                  <a:off x="4618071" y="2779006"/>
                  <a:ext cx="36420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 smtClean="0"/>
                    <a:t>4000</a:t>
                  </a:r>
                  <a:endParaRPr lang="ru-RU" sz="700" b="1" dirty="0"/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 rot="2700000">
                  <a:off x="5390627" y="2790889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5000</a:t>
                  </a:r>
                  <a:endParaRPr lang="ru-RU" sz="700" b="1" dirty="0"/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 rot="2700000">
                  <a:off x="6189248" y="2790889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6000</a:t>
                  </a:r>
                  <a:endParaRPr lang="ru-RU" sz="700" b="1" dirty="0"/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 rot="2700000">
                  <a:off x="6969492" y="2790490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7000</a:t>
                  </a:r>
                  <a:endParaRPr lang="ru-RU" sz="700" b="1" dirty="0"/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 rot="2700000">
                  <a:off x="7776158" y="2785747"/>
                  <a:ext cx="3953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/>
                    <a:t>8000</a:t>
                  </a:r>
                  <a:endParaRPr lang="ru-RU" sz="700" b="1" dirty="0"/>
                </a:p>
              </p:txBody>
            </p:sp>
          </p:grpSp>
        </p:grpSp>
        <p:sp>
          <p:nvSpPr>
            <p:cNvPr id="85" name="TextBox 84"/>
            <p:cNvSpPr txBox="1"/>
            <p:nvPr/>
          </p:nvSpPr>
          <p:spPr>
            <a:xfrm rot="16200000">
              <a:off x="5213140" y="1802317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2</a:t>
              </a:r>
              <a:endParaRPr lang="ru-RU" sz="800" dirty="0"/>
            </a:p>
          </p:txBody>
        </p:sp>
        <p:sp>
          <p:nvSpPr>
            <p:cNvPr id="88" name="TextBox 87"/>
            <p:cNvSpPr txBox="1"/>
            <p:nvPr/>
          </p:nvSpPr>
          <p:spPr>
            <a:xfrm rot="16200000">
              <a:off x="5213141" y="54172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2</a:t>
              </a:r>
              <a:endParaRPr lang="ru-RU" sz="800" dirty="0"/>
            </a:p>
          </p:txBody>
        </p:sp>
        <p:sp>
          <p:nvSpPr>
            <p:cNvPr id="89" name="TextBox 88"/>
            <p:cNvSpPr txBox="1"/>
            <p:nvPr/>
          </p:nvSpPr>
          <p:spPr>
            <a:xfrm rot="16200000">
              <a:off x="5320862" y="1829802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4</a:t>
              </a:r>
              <a:endParaRPr lang="ru-RU" sz="800" dirty="0"/>
            </a:p>
          </p:txBody>
        </p:sp>
        <p:sp>
          <p:nvSpPr>
            <p:cNvPr id="90" name="TextBox 89"/>
            <p:cNvSpPr txBox="1"/>
            <p:nvPr/>
          </p:nvSpPr>
          <p:spPr>
            <a:xfrm rot="16200000">
              <a:off x="5318872" y="1022089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4</a:t>
              </a:r>
              <a:endParaRPr lang="ru-RU" sz="800" dirty="0"/>
            </a:p>
          </p:txBody>
        </p:sp>
        <p:sp>
          <p:nvSpPr>
            <p:cNvPr id="91" name="TextBox 90"/>
            <p:cNvSpPr txBox="1"/>
            <p:nvPr/>
          </p:nvSpPr>
          <p:spPr>
            <a:xfrm rot="16200000">
              <a:off x="5462358" y="1676904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5</a:t>
              </a:r>
              <a:endParaRPr lang="ru-RU" sz="800" dirty="0"/>
            </a:p>
          </p:txBody>
        </p:sp>
        <p:sp>
          <p:nvSpPr>
            <p:cNvPr id="92" name="TextBox 91"/>
            <p:cNvSpPr txBox="1"/>
            <p:nvPr/>
          </p:nvSpPr>
          <p:spPr>
            <a:xfrm rot="16200000">
              <a:off x="5462327" y="582970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5</a:t>
              </a:r>
              <a:endParaRPr lang="ru-RU" sz="800" dirty="0"/>
            </a:p>
          </p:txBody>
        </p:sp>
        <p:sp>
          <p:nvSpPr>
            <p:cNvPr id="93" name="TextBox 92"/>
            <p:cNvSpPr txBox="1"/>
            <p:nvPr/>
          </p:nvSpPr>
          <p:spPr>
            <a:xfrm rot="16200000">
              <a:off x="5618492" y="2002358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6</a:t>
              </a:r>
              <a:endParaRPr lang="ru-RU" sz="800" dirty="0"/>
            </a:p>
          </p:txBody>
        </p:sp>
        <p:sp>
          <p:nvSpPr>
            <p:cNvPr id="94" name="TextBox 93"/>
            <p:cNvSpPr txBox="1"/>
            <p:nvPr/>
          </p:nvSpPr>
          <p:spPr>
            <a:xfrm rot="16200000">
              <a:off x="5729309" y="220414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7</a:t>
              </a:r>
              <a:endParaRPr lang="ru-RU" sz="800" dirty="0"/>
            </a:p>
          </p:txBody>
        </p:sp>
        <p:sp>
          <p:nvSpPr>
            <p:cNvPr id="95" name="TextBox 94"/>
            <p:cNvSpPr txBox="1"/>
            <p:nvPr/>
          </p:nvSpPr>
          <p:spPr>
            <a:xfrm rot="16200000">
              <a:off x="5833937" y="2391392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8</a:t>
              </a:r>
              <a:endParaRPr lang="ru-RU" sz="800" dirty="0"/>
            </a:p>
          </p:txBody>
        </p:sp>
        <p:sp>
          <p:nvSpPr>
            <p:cNvPr id="96" name="TextBox 95"/>
            <p:cNvSpPr txBox="1"/>
            <p:nvPr/>
          </p:nvSpPr>
          <p:spPr>
            <a:xfrm rot="16200000">
              <a:off x="5982964" y="2409404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9</a:t>
              </a:r>
              <a:endParaRPr lang="ru-RU" sz="800" dirty="0"/>
            </a:p>
          </p:txBody>
        </p:sp>
        <p:sp>
          <p:nvSpPr>
            <p:cNvPr id="97" name="TextBox 96"/>
            <p:cNvSpPr txBox="1"/>
            <p:nvPr/>
          </p:nvSpPr>
          <p:spPr>
            <a:xfrm rot="16200000">
              <a:off x="6100735" y="2501233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0</a:t>
              </a:r>
              <a:endParaRPr lang="ru-RU" sz="800" dirty="0"/>
            </a:p>
          </p:txBody>
        </p:sp>
        <p:sp>
          <p:nvSpPr>
            <p:cNvPr id="98" name="TextBox 97"/>
            <p:cNvSpPr txBox="1"/>
            <p:nvPr/>
          </p:nvSpPr>
          <p:spPr>
            <a:xfrm rot="16200000">
              <a:off x="6295117" y="2425541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2</a:t>
              </a:r>
              <a:endParaRPr lang="ru-RU" sz="800" dirty="0"/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6573473" y="2460829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5</a:t>
              </a:r>
              <a:endParaRPr lang="ru-RU" sz="800" dirty="0"/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6694883" y="2433922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6</a:t>
              </a:r>
              <a:endParaRPr lang="ru-RU" sz="800" dirty="0"/>
            </a:p>
          </p:txBody>
        </p:sp>
        <p:sp>
          <p:nvSpPr>
            <p:cNvPr id="101" name="TextBox 100"/>
            <p:cNvSpPr txBox="1"/>
            <p:nvPr/>
          </p:nvSpPr>
          <p:spPr>
            <a:xfrm rot="16200000">
              <a:off x="5616384" y="1298408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6</a:t>
              </a:r>
              <a:endParaRPr lang="ru-RU" sz="800" dirty="0"/>
            </a:p>
          </p:txBody>
        </p:sp>
        <p:sp>
          <p:nvSpPr>
            <p:cNvPr id="102" name="TextBox 101"/>
            <p:cNvSpPr txBox="1"/>
            <p:nvPr/>
          </p:nvSpPr>
          <p:spPr>
            <a:xfrm rot="16200000">
              <a:off x="6782513" y="2251042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7</a:t>
              </a:r>
              <a:endParaRPr lang="ru-RU" sz="800" dirty="0"/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6866333" y="2235802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8</a:t>
              </a:r>
              <a:endParaRPr lang="ru-RU" sz="800" dirty="0"/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6920548" y="245692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9</a:t>
              </a:r>
              <a:endParaRPr lang="ru-RU" sz="800" dirty="0"/>
            </a:p>
          </p:txBody>
        </p:sp>
        <p:sp>
          <p:nvSpPr>
            <p:cNvPr id="105" name="TextBox 104"/>
            <p:cNvSpPr txBox="1"/>
            <p:nvPr/>
          </p:nvSpPr>
          <p:spPr>
            <a:xfrm rot="16200000">
              <a:off x="7050088" y="244930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0</a:t>
              </a:r>
              <a:endParaRPr lang="ru-RU" sz="800" dirty="0"/>
            </a:p>
          </p:txBody>
        </p:sp>
        <p:sp>
          <p:nvSpPr>
            <p:cNvPr id="106" name="TextBox 105"/>
            <p:cNvSpPr txBox="1"/>
            <p:nvPr/>
          </p:nvSpPr>
          <p:spPr>
            <a:xfrm rot="16200000">
              <a:off x="7164388" y="231214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1</a:t>
              </a:r>
              <a:endParaRPr lang="ru-RU" sz="800" dirty="0"/>
            </a:p>
          </p:txBody>
        </p:sp>
        <p:sp>
          <p:nvSpPr>
            <p:cNvPr id="107" name="TextBox 106"/>
            <p:cNvSpPr txBox="1"/>
            <p:nvPr/>
          </p:nvSpPr>
          <p:spPr>
            <a:xfrm rot="16200000">
              <a:off x="7282498" y="236167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2</a:t>
              </a:r>
              <a:endParaRPr lang="ru-RU" sz="800" dirty="0"/>
            </a:p>
          </p:txBody>
        </p:sp>
        <p:sp>
          <p:nvSpPr>
            <p:cNvPr id="108" name="TextBox 107"/>
            <p:cNvSpPr txBox="1"/>
            <p:nvPr/>
          </p:nvSpPr>
          <p:spPr>
            <a:xfrm rot="16200000">
              <a:off x="7720648" y="230833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6</a:t>
              </a:r>
              <a:endParaRPr lang="ru-RU" sz="800" dirty="0"/>
            </a:p>
          </p:txBody>
        </p:sp>
        <p:sp>
          <p:nvSpPr>
            <p:cNvPr id="109" name="TextBox 108"/>
            <p:cNvSpPr txBox="1"/>
            <p:nvPr/>
          </p:nvSpPr>
          <p:spPr>
            <a:xfrm rot="16200000">
              <a:off x="7838758" y="210259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8</a:t>
              </a:r>
              <a:endParaRPr lang="ru-RU" sz="800" dirty="0"/>
            </a:p>
          </p:txBody>
        </p:sp>
        <p:sp>
          <p:nvSpPr>
            <p:cNvPr id="110" name="TextBox 109"/>
            <p:cNvSpPr txBox="1"/>
            <p:nvPr/>
          </p:nvSpPr>
          <p:spPr>
            <a:xfrm rot="16200000">
              <a:off x="7991158" y="238072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9</a:t>
              </a:r>
              <a:endParaRPr lang="ru-RU" sz="800" dirty="0"/>
            </a:p>
          </p:txBody>
        </p:sp>
        <p:sp>
          <p:nvSpPr>
            <p:cNvPr id="111" name="TextBox 110"/>
            <p:cNvSpPr txBox="1"/>
            <p:nvPr/>
          </p:nvSpPr>
          <p:spPr>
            <a:xfrm rot="16200000">
              <a:off x="8105458" y="204544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70</a:t>
              </a:r>
              <a:endParaRPr lang="ru-RU" sz="800" dirty="0"/>
            </a:p>
          </p:txBody>
        </p:sp>
        <p:sp>
          <p:nvSpPr>
            <p:cNvPr id="112" name="TextBox 111"/>
            <p:cNvSpPr txBox="1"/>
            <p:nvPr/>
          </p:nvSpPr>
          <p:spPr>
            <a:xfrm rot="16200000">
              <a:off x="8219758" y="236929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71</a:t>
              </a:r>
              <a:endParaRPr lang="ru-RU" sz="800" dirty="0"/>
            </a:p>
          </p:txBody>
        </p:sp>
        <p:sp>
          <p:nvSpPr>
            <p:cNvPr id="113" name="TextBox 112"/>
            <p:cNvSpPr txBox="1"/>
            <p:nvPr/>
          </p:nvSpPr>
          <p:spPr>
            <a:xfrm rot="16200000">
              <a:off x="8334058" y="244930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72</a:t>
              </a:r>
              <a:endParaRPr lang="ru-RU" sz="800" dirty="0"/>
            </a:p>
          </p:txBody>
        </p:sp>
        <p:sp>
          <p:nvSpPr>
            <p:cNvPr id="114" name="TextBox 113"/>
            <p:cNvSpPr txBox="1"/>
            <p:nvPr/>
          </p:nvSpPr>
          <p:spPr>
            <a:xfrm rot="16200000">
              <a:off x="4876501" y="388269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38</a:t>
              </a:r>
              <a:endParaRPr lang="ru-RU" sz="800" dirty="0"/>
            </a:p>
          </p:txBody>
        </p:sp>
        <p:sp>
          <p:nvSpPr>
            <p:cNvPr id="115" name="TextBox 114"/>
            <p:cNvSpPr txBox="1"/>
            <p:nvPr/>
          </p:nvSpPr>
          <p:spPr>
            <a:xfrm rot="16200000">
              <a:off x="5215703" y="3188542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2</a:t>
              </a:r>
              <a:endParaRPr lang="ru-RU" sz="800" dirty="0"/>
            </a:p>
          </p:txBody>
        </p:sp>
        <p:sp>
          <p:nvSpPr>
            <p:cNvPr id="116" name="TextBox 115"/>
            <p:cNvSpPr txBox="1"/>
            <p:nvPr/>
          </p:nvSpPr>
          <p:spPr>
            <a:xfrm rot="16200000">
              <a:off x="5322321" y="3855309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4</a:t>
              </a:r>
              <a:endParaRPr lang="ru-RU" sz="800" dirty="0"/>
            </a:p>
          </p:txBody>
        </p:sp>
        <p:sp>
          <p:nvSpPr>
            <p:cNvPr id="117" name="TextBox 116"/>
            <p:cNvSpPr txBox="1"/>
            <p:nvPr/>
          </p:nvSpPr>
          <p:spPr>
            <a:xfrm rot="16200000">
              <a:off x="5462326" y="3526622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5</a:t>
              </a:r>
              <a:endParaRPr lang="ru-RU" sz="800" dirty="0"/>
            </a:p>
          </p:txBody>
        </p:sp>
        <p:sp>
          <p:nvSpPr>
            <p:cNvPr id="118" name="TextBox 117"/>
            <p:cNvSpPr txBox="1"/>
            <p:nvPr/>
          </p:nvSpPr>
          <p:spPr>
            <a:xfrm rot="16200000">
              <a:off x="5606821" y="388428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46</a:t>
              </a:r>
              <a:endParaRPr lang="ru-RU" sz="800" dirty="0"/>
            </a:p>
          </p:txBody>
        </p:sp>
        <p:sp>
          <p:nvSpPr>
            <p:cNvPr id="119" name="TextBox 118"/>
            <p:cNvSpPr txBox="1"/>
            <p:nvPr/>
          </p:nvSpPr>
          <p:spPr>
            <a:xfrm rot="16200000">
              <a:off x="6874024" y="3882694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8</a:t>
              </a:r>
              <a:endParaRPr lang="ru-RU" sz="800" dirty="0"/>
            </a:p>
          </p:txBody>
        </p:sp>
        <p:sp>
          <p:nvSpPr>
            <p:cNvPr id="120" name="TextBox 119"/>
            <p:cNvSpPr txBox="1"/>
            <p:nvPr/>
          </p:nvSpPr>
          <p:spPr>
            <a:xfrm rot="16200000">
              <a:off x="6775620" y="3881890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57</a:t>
              </a:r>
              <a:endParaRPr lang="ru-RU" sz="800" dirty="0"/>
            </a:p>
          </p:txBody>
        </p:sp>
        <p:sp>
          <p:nvSpPr>
            <p:cNvPr id="121" name="TextBox 120"/>
            <p:cNvSpPr txBox="1"/>
            <p:nvPr/>
          </p:nvSpPr>
          <p:spPr>
            <a:xfrm rot="16200000">
              <a:off x="7290193" y="3891041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2</a:t>
              </a:r>
              <a:endParaRPr lang="ru-RU" sz="800" dirty="0"/>
            </a:p>
          </p:txBody>
        </p:sp>
        <p:sp>
          <p:nvSpPr>
            <p:cNvPr id="122" name="TextBox 121"/>
            <p:cNvSpPr txBox="1"/>
            <p:nvPr/>
          </p:nvSpPr>
          <p:spPr>
            <a:xfrm rot="16200000">
              <a:off x="7164225" y="3881889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1</a:t>
              </a:r>
              <a:endParaRPr lang="ru-RU" sz="800" dirty="0"/>
            </a:p>
          </p:txBody>
        </p:sp>
        <p:sp>
          <p:nvSpPr>
            <p:cNvPr id="123" name="TextBox 122"/>
            <p:cNvSpPr txBox="1"/>
            <p:nvPr/>
          </p:nvSpPr>
          <p:spPr>
            <a:xfrm rot="16200000">
              <a:off x="8105459" y="130673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70</a:t>
              </a:r>
              <a:endParaRPr lang="ru-RU" sz="800" dirty="0"/>
            </a:p>
          </p:txBody>
        </p:sp>
        <p:sp>
          <p:nvSpPr>
            <p:cNvPr id="124" name="TextBox 123"/>
            <p:cNvSpPr txBox="1"/>
            <p:nvPr/>
          </p:nvSpPr>
          <p:spPr>
            <a:xfrm rot="16200000">
              <a:off x="7838759" y="3907335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8</a:t>
              </a:r>
              <a:endParaRPr lang="ru-RU" sz="800" dirty="0"/>
            </a:p>
          </p:txBody>
        </p:sp>
        <p:sp>
          <p:nvSpPr>
            <p:cNvPr id="125" name="TextBox 124"/>
            <p:cNvSpPr txBox="1"/>
            <p:nvPr/>
          </p:nvSpPr>
          <p:spPr>
            <a:xfrm rot="16200000">
              <a:off x="7727430" y="3914827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67</a:t>
              </a:r>
              <a:endParaRPr lang="ru-RU" sz="800" dirty="0"/>
            </a:p>
          </p:txBody>
        </p:sp>
        <p:sp>
          <p:nvSpPr>
            <p:cNvPr id="126" name="TextBox 125"/>
            <p:cNvSpPr txBox="1"/>
            <p:nvPr/>
          </p:nvSpPr>
          <p:spPr>
            <a:xfrm rot="16200000">
              <a:off x="8105457" y="3737619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70</a:t>
              </a:r>
              <a:endParaRPr lang="ru-RU" sz="800" dirty="0"/>
            </a:p>
          </p:txBody>
        </p:sp>
        <p:sp>
          <p:nvSpPr>
            <p:cNvPr id="127" name="TextBox 126"/>
            <p:cNvSpPr txBox="1"/>
            <p:nvPr/>
          </p:nvSpPr>
          <p:spPr>
            <a:xfrm rot="16200000">
              <a:off x="8237113" y="3915216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71</a:t>
              </a:r>
              <a:endParaRPr lang="ru-RU" sz="800" dirty="0"/>
            </a:p>
          </p:txBody>
        </p:sp>
        <p:sp>
          <p:nvSpPr>
            <p:cNvPr id="128" name="TextBox 127"/>
            <p:cNvSpPr txBox="1"/>
            <p:nvPr/>
          </p:nvSpPr>
          <p:spPr>
            <a:xfrm rot="16200000">
              <a:off x="4884315" y="2325391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38</a:t>
              </a:r>
              <a:endParaRPr lang="ru-RU" sz="800" dirty="0"/>
            </a:p>
          </p:txBody>
        </p:sp>
        <p:sp>
          <p:nvSpPr>
            <p:cNvPr id="129" name="TextBox 128"/>
            <p:cNvSpPr txBox="1"/>
            <p:nvPr/>
          </p:nvSpPr>
          <p:spPr>
            <a:xfrm rot="16200000">
              <a:off x="4890972" y="1198813"/>
              <a:ext cx="3807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2-38</a:t>
              </a:r>
              <a:endParaRPr lang="ru-RU" sz="800" dirty="0"/>
            </a:p>
          </p:txBody>
        </p:sp>
        <p:sp>
          <p:nvSpPr>
            <p:cNvPr id="130" name="TextBox 129"/>
            <p:cNvSpPr txBox="1"/>
            <p:nvPr/>
          </p:nvSpPr>
          <p:spPr>
            <a:xfrm rot="16200000">
              <a:off x="4783298" y="3300310"/>
              <a:ext cx="9655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fragment of Rnq1</a:t>
              </a:r>
              <a:endParaRPr lang="ru-RU" sz="800" dirty="0"/>
            </a:p>
          </p:txBody>
        </p:sp>
      </p:grpSp>
      <p:sp>
        <p:nvSpPr>
          <p:cNvPr id="5" name="Прямоугольник 4"/>
          <p:cNvSpPr/>
          <p:nvPr/>
        </p:nvSpPr>
        <p:spPr>
          <a:xfrm>
            <a:off x="438896" y="5424768"/>
            <a:ext cx="1134197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PrK</a:t>
            </a:r>
            <a:r>
              <a:rPr lang="en-US" dirty="0"/>
              <a:t>-resistant cores of </a:t>
            </a:r>
            <a:r>
              <a:rPr lang="en-US" dirty="0" smtClean="0"/>
              <a:t>Sup35PD-GFP </a:t>
            </a:r>
            <a:r>
              <a:rPr lang="en-US" dirty="0"/>
              <a:t>prion polymers </a:t>
            </a:r>
            <a:r>
              <a:rPr lang="en-US" dirty="0" smtClean="0"/>
              <a:t>extracted from weak </a:t>
            </a:r>
            <a:r>
              <a:rPr lang="en-US" dirty="0"/>
              <a:t>[PSI+] </a:t>
            </a:r>
            <a:r>
              <a:rPr lang="en-US" dirty="0" smtClean="0"/>
              <a:t>isolates, </a:t>
            </a:r>
            <a:r>
              <a:rPr lang="en-US" dirty="0"/>
              <a:t>emerged in either </a:t>
            </a:r>
            <a:r>
              <a:rPr lang="el-GR" dirty="0"/>
              <a:t>Δ</a:t>
            </a:r>
            <a:r>
              <a:rPr lang="en-US" dirty="0"/>
              <a:t>rnq1 or [RNQ+] cells. Sup35PD-GFP fibrils, sonicated and isolated from yeast cell lysates in the presence of </a:t>
            </a:r>
            <a:r>
              <a:rPr lang="en-US" dirty="0" err="1"/>
              <a:t>sarcosyl</a:t>
            </a:r>
            <a:r>
              <a:rPr lang="en-US" dirty="0"/>
              <a:t>, were treated for 1 </a:t>
            </a:r>
            <a:r>
              <a:rPr lang="en-US" dirty="0" err="1"/>
              <a:t>hr</a:t>
            </a:r>
            <a:r>
              <a:rPr lang="en-US" dirty="0"/>
              <a:t> with </a:t>
            </a:r>
            <a:r>
              <a:rPr lang="el-GR" dirty="0"/>
              <a:t>25 μ</a:t>
            </a:r>
            <a:r>
              <a:rPr lang="en-US" dirty="0"/>
              <a:t>g/ml</a:t>
            </a:r>
            <a:r>
              <a:rPr lang="ru-RU" dirty="0"/>
              <a:t> </a:t>
            </a:r>
            <a:r>
              <a:rPr lang="en-US" dirty="0"/>
              <a:t>proteinase K, and proteinase K-resistant peptides were analyzed with MALDI-TOF. </a:t>
            </a:r>
            <a:r>
              <a:rPr lang="en-US" dirty="0" smtClean="0"/>
              <a:t>The left </a:t>
            </a:r>
            <a:r>
              <a:rPr lang="en-US" dirty="0"/>
              <a:t>panels show </a:t>
            </a:r>
            <a:r>
              <a:rPr lang="en-US" dirty="0" err="1"/>
              <a:t>PrK</a:t>
            </a:r>
            <a:r>
              <a:rPr lang="en-US" dirty="0"/>
              <a:t> resistance index profiles, and the right panels show a part of </a:t>
            </a:r>
            <a:r>
              <a:rPr lang="en-US" dirty="0" smtClean="0"/>
              <a:t>the MALDI-TOF </a:t>
            </a:r>
            <a:r>
              <a:rPr lang="en-US" dirty="0"/>
              <a:t>mass spectra (linear mode) </a:t>
            </a:r>
            <a:r>
              <a:rPr lang="en-US" dirty="0" smtClean="0"/>
              <a:t>containing the </a:t>
            </a:r>
            <a:r>
              <a:rPr lang="en-US" dirty="0"/>
              <a:t>Core 1 peptides. </a:t>
            </a:r>
            <a:r>
              <a:rPr lang="en-US" dirty="0" err="1" smtClean="0"/>
              <a:t>Unlabelled</a:t>
            </a:r>
            <a:r>
              <a:rPr lang="en-US" dirty="0" smtClean="0"/>
              <a:t> </a:t>
            </a:r>
            <a:r>
              <a:rPr lang="en-US" dirty="0"/>
              <a:t>peaks represent parts of Cores 2-4. Note </a:t>
            </a:r>
            <a:r>
              <a:rPr lang="en-US" dirty="0" smtClean="0"/>
              <a:t>that the </a:t>
            </a:r>
            <a:r>
              <a:rPr lang="en-US" dirty="0"/>
              <a:t>N-terminal methionine of </a:t>
            </a:r>
            <a:r>
              <a:rPr lang="en-US" dirty="0" smtClean="0"/>
              <a:t>Sup35PD-GFP has been completely </a:t>
            </a:r>
            <a:r>
              <a:rPr lang="en-US" dirty="0"/>
              <a:t>removed and replaced with an acetyl </a:t>
            </a:r>
            <a:r>
              <a:rPr lang="en-US" dirty="0" smtClean="0"/>
              <a:t>group in the yeast cells, </a:t>
            </a:r>
            <a:r>
              <a:rPr lang="en-US" dirty="0"/>
              <a:t>and therefore all Core 1 peaks start from </a:t>
            </a:r>
            <a:r>
              <a:rPr lang="en-US" dirty="0" smtClean="0"/>
              <a:t>the amino </a:t>
            </a:r>
            <a:r>
              <a:rPr lang="en-US" dirty="0"/>
              <a:t>acid </a:t>
            </a:r>
            <a:r>
              <a:rPr lang="en-US" dirty="0" smtClean="0"/>
              <a:t>residue </a:t>
            </a:r>
            <a:r>
              <a:rPr lang="ru-RU" dirty="0" smtClean="0"/>
              <a:t>№</a:t>
            </a:r>
            <a:r>
              <a:rPr lang="en-US" dirty="0"/>
              <a:t>2.</a:t>
            </a:r>
            <a:endParaRPr lang="ru-RU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44817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7914833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6</TotalTime>
  <Words>275</Words>
  <Application>Microsoft Office PowerPoint</Application>
  <PresentationFormat>Произвольный</PresentationFormat>
  <Paragraphs>84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7" baseType="lpstr">
      <vt:lpstr>Microsoft YaHei</vt:lpstr>
      <vt:lpstr>Arial</vt:lpstr>
      <vt:lpstr>Calibri</vt:lpstr>
      <vt:lpstr>Calibri Light</vt:lpstr>
      <vt:lpstr>Тема Office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лександр Дергалёв</dc:creator>
  <cp:lastModifiedBy>Александр Дергалёв</cp:lastModifiedBy>
  <cp:revision>46</cp:revision>
  <dcterms:created xsi:type="dcterms:W3CDTF">2023-08-09T20:22:04Z</dcterms:created>
  <dcterms:modified xsi:type="dcterms:W3CDTF">2023-11-12T02:08:46Z</dcterms:modified>
</cp:coreProperties>
</file>